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732" r:id="rId1"/>
  </p:sldMasterIdLst>
  <p:notesMasterIdLst>
    <p:notesMasterId r:id="rId3"/>
  </p:notesMasterIdLst>
  <p:sldIdLst>
    <p:sldId id="270" r:id="rId2"/>
  </p:sldIdLst>
  <p:sldSz cx="23183850" cy="17387888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Ana Faria" initials="AF" lastIdx="1" clrIdx="0">
    <p:extLst>
      <p:ext uri="{19B8F6BF-5375-455C-9EA6-DF929625EA0E}">
        <p15:presenceInfo xmlns:p15="http://schemas.microsoft.com/office/powerpoint/2012/main" userId="S::ana.faria@nms.unl.pt::4548fc6f-7f5e-48fb-8ed7-79e5838b4f39" providerId="AD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9086"/>
    <a:srgbClr val="00DAE0"/>
    <a:srgbClr val="7EB2D5"/>
    <a:srgbClr val="FFED6F"/>
    <a:srgbClr val="ECEC8D"/>
    <a:srgbClr val="DAEBAC"/>
    <a:srgbClr val="CAE4C4"/>
    <a:srgbClr val="C5BEC1"/>
    <a:srgbClr val="BF98BE"/>
    <a:srgbClr val="BF8BC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3" autoAdjust="0"/>
    <p:restoredTop sz="94663"/>
  </p:normalViewPr>
  <p:slideViewPr>
    <p:cSldViewPr snapToGrid="0">
      <p:cViewPr>
        <p:scale>
          <a:sx n="50" d="100"/>
          <a:sy n="50" d="100"/>
        </p:scale>
        <p:origin x="130" y="-183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commentAuthors" Target="commentAuthor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Posição do Cabeçalho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Marcador de Posição da Data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EAF907BE-7C59-4D88-AFFC-DD679AA1D447}" type="datetimeFigureOut">
              <a:rPr lang="en-GB" smtClean="0"/>
              <a:t>26/02/2021</a:t>
            </a:fld>
            <a:endParaRPr lang="en-GB"/>
          </a:p>
        </p:txBody>
      </p:sp>
      <p:sp>
        <p:nvSpPr>
          <p:cNvPr id="4" name="Marcador de Posição da Imagem do Diapositivo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Marcador de Posição de Notas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pt-PT"/>
              <a:t>Clique para editar os estilos do texto de Modelo Global</a:t>
            </a:r>
          </a:p>
          <a:p>
            <a:pPr lvl="1"/>
            <a:r>
              <a:rPr lang="pt-PT"/>
              <a:t>Segundo nível</a:t>
            </a:r>
          </a:p>
          <a:p>
            <a:pPr lvl="2"/>
            <a:r>
              <a:rPr lang="pt-PT"/>
              <a:t>Terceiro nível</a:t>
            </a:r>
          </a:p>
          <a:p>
            <a:pPr lvl="3"/>
            <a:r>
              <a:rPr lang="pt-PT"/>
              <a:t>Quarto nível</a:t>
            </a:r>
          </a:p>
          <a:p>
            <a:pPr lvl="4"/>
            <a:r>
              <a:rPr lang="pt-PT"/>
              <a:t>Quinto nível</a:t>
            </a:r>
            <a:endParaRPr lang="en-GB"/>
          </a:p>
        </p:txBody>
      </p:sp>
      <p:sp>
        <p:nvSpPr>
          <p:cNvPr id="6" name="Marcador de Posição do Rodapé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Marcador de Posição do Número do Diapositivo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ECD33ED8-7FDA-4B9F-BBCE-17741599C0E8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22880958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45508" rtl="0" eaLnBrk="1" latinLnBrk="0" hangingPunct="1">
      <a:defRPr sz="1241" kern="1200">
        <a:solidFill>
          <a:schemeClr val="tx1"/>
        </a:solidFill>
        <a:latin typeface="+mn-lt"/>
        <a:ea typeface="+mn-ea"/>
        <a:cs typeface="+mn-cs"/>
      </a:defRPr>
    </a:lvl1pPr>
    <a:lvl2pPr marL="472754" algn="l" defTabSz="945508" rtl="0" eaLnBrk="1" latinLnBrk="0" hangingPunct="1">
      <a:defRPr sz="1241" kern="1200">
        <a:solidFill>
          <a:schemeClr val="tx1"/>
        </a:solidFill>
        <a:latin typeface="+mn-lt"/>
        <a:ea typeface="+mn-ea"/>
        <a:cs typeface="+mn-cs"/>
      </a:defRPr>
    </a:lvl2pPr>
    <a:lvl3pPr marL="945508" algn="l" defTabSz="945508" rtl="0" eaLnBrk="1" latinLnBrk="0" hangingPunct="1">
      <a:defRPr sz="1241" kern="1200">
        <a:solidFill>
          <a:schemeClr val="tx1"/>
        </a:solidFill>
        <a:latin typeface="+mn-lt"/>
        <a:ea typeface="+mn-ea"/>
        <a:cs typeface="+mn-cs"/>
      </a:defRPr>
    </a:lvl3pPr>
    <a:lvl4pPr marL="1418261" algn="l" defTabSz="945508" rtl="0" eaLnBrk="1" latinLnBrk="0" hangingPunct="1">
      <a:defRPr sz="1241" kern="1200">
        <a:solidFill>
          <a:schemeClr val="tx1"/>
        </a:solidFill>
        <a:latin typeface="+mn-lt"/>
        <a:ea typeface="+mn-ea"/>
        <a:cs typeface="+mn-cs"/>
      </a:defRPr>
    </a:lvl4pPr>
    <a:lvl5pPr marL="1891015" algn="l" defTabSz="945508" rtl="0" eaLnBrk="1" latinLnBrk="0" hangingPunct="1">
      <a:defRPr sz="1241" kern="1200">
        <a:solidFill>
          <a:schemeClr val="tx1"/>
        </a:solidFill>
        <a:latin typeface="+mn-lt"/>
        <a:ea typeface="+mn-ea"/>
        <a:cs typeface="+mn-cs"/>
      </a:defRPr>
    </a:lvl5pPr>
    <a:lvl6pPr marL="2363769" algn="l" defTabSz="945508" rtl="0" eaLnBrk="1" latinLnBrk="0" hangingPunct="1">
      <a:defRPr sz="1241" kern="1200">
        <a:solidFill>
          <a:schemeClr val="tx1"/>
        </a:solidFill>
        <a:latin typeface="+mn-lt"/>
        <a:ea typeface="+mn-ea"/>
        <a:cs typeface="+mn-cs"/>
      </a:defRPr>
    </a:lvl6pPr>
    <a:lvl7pPr marL="2836522" algn="l" defTabSz="945508" rtl="0" eaLnBrk="1" latinLnBrk="0" hangingPunct="1">
      <a:defRPr sz="1241" kern="1200">
        <a:solidFill>
          <a:schemeClr val="tx1"/>
        </a:solidFill>
        <a:latin typeface="+mn-lt"/>
        <a:ea typeface="+mn-ea"/>
        <a:cs typeface="+mn-cs"/>
      </a:defRPr>
    </a:lvl7pPr>
    <a:lvl8pPr marL="3309275" algn="l" defTabSz="945508" rtl="0" eaLnBrk="1" latinLnBrk="0" hangingPunct="1">
      <a:defRPr sz="1241" kern="1200">
        <a:solidFill>
          <a:schemeClr val="tx1"/>
        </a:solidFill>
        <a:latin typeface="+mn-lt"/>
        <a:ea typeface="+mn-ea"/>
        <a:cs typeface="+mn-cs"/>
      </a:defRPr>
    </a:lvl8pPr>
    <a:lvl9pPr marL="3782029" algn="l" defTabSz="945508" rtl="0" eaLnBrk="1" latinLnBrk="0" hangingPunct="1">
      <a:defRPr sz="1241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o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738789" y="2845658"/>
            <a:ext cx="19706273" cy="6053561"/>
          </a:xfrm>
        </p:spPr>
        <p:txBody>
          <a:bodyPr anchor="b"/>
          <a:lstStyle>
            <a:lvl1pPr algn="ctr">
              <a:defRPr sz="15212"/>
            </a:lvl1pPr>
          </a:lstStyle>
          <a:p>
            <a:r>
              <a:rPr lang="pt-PT"/>
              <a:t>Clique para editar o estilo de título do Modelo Global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2897981" y="9132667"/>
            <a:ext cx="17387888" cy="4198047"/>
          </a:xfrm>
        </p:spPr>
        <p:txBody>
          <a:bodyPr/>
          <a:lstStyle>
            <a:lvl1pPr marL="0" indent="0" algn="ctr">
              <a:buNone/>
              <a:defRPr sz="6085"/>
            </a:lvl1pPr>
            <a:lvl2pPr marL="1159185" indent="0" algn="ctr">
              <a:buNone/>
              <a:defRPr sz="5071"/>
            </a:lvl2pPr>
            <a:lvl3pPr marL="2318370" indent="0" algn="ctr">
              <a:buNone/>
              <a:defRPr sz="4564"/>
            </a:lvl3pPr>
            <a:lvl4pPr marL="3477555" indent="0" algn="ctr">
              <a:buNone/>
              <a:defRPr sz="4057"/>
            </a:lvl4pPr>
            <a:lvl5pPr marL="4636740" indent="0" algn="ctr">
              <a:buNone/>
              <a:defRPr sz="4057"/>
            </a:lvl5pPr>
            <a:lvl6pPr marL="5795924" indent="0" algn="ctr">
              <a:buNone/>
              <a:defRPr sz="4057"/>
            </a:lvl6pPr>
            <a:lvl7pPr marL="6955109" indent="0" algn="ctr">
              <a:buNone/>
              <a:defRPr sz="4057"/>
            </a:lvl7pPr>
            <a:lvl8pPr marL="8114294" indent="0" algn="ctr">
              <a:buNone/>
              <a:defRPr sz="4057"/>
            </a:lvl8pPr>
            <a:lvl9pPr marL="9273479" indent="0" algn="ctr">
              <a:buNone/>
              <a:defRPr sz="4057"/>
            </a:lvl9pPr>
          </a:lstStyle>
          <a:p>
            <a:r>
              <a:rPr lang="pt-PT"/>
              <a:t>Clique para editar o estilo de subtítulo do Modelo Globa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A616BE-27E2-40FC-8B61-BDA185EFADEF}" type="datetimeFigureOut">
              <a:rPr lang="en-GB" smtClean="0"/>
              <a:t>26/02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742DD5-0C0E-43B2-8265-2B3269F610A4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5440744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e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PT"/>
              <a:t>Clique para editar o estilo de título do Modelo Global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pt-PT"/>
              <a:t>Clique para editar os estilos do texto de Modelo Global</a:t>
            </a:r>
          </a:p>
          <a:p>
            <a:pPr lvl="1"/>
            <a:r>
              <a:rPr lang="pt-PT"/>
              <a:t>Segundo nível</a:t>
            </a:r>
          </a:p>
          <a:p>
            <a:pPr lvl="2"/>
            <a:r>
              <a:rPr lang="pt-PT"/>
              <a:t>Terceiro nível</a:t>
            </a:r>
          </a:p>
          <a:p>
            <a:pPr lvl="3"/>
            <a:r>
              <a:rPr lang="pt-PT"/>
              <a:t>Quarto nível</a:t>
            </a:r>
          </a:p>
          <a:p>
            <a:pPr lvl="4"/>
            <a:r>
              <a:rPr lang="pt-PT"/>
              <a:t>Quinto ní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A616BE-27E2-40FC-8B61-BDA185EFADEF}" type="datetimeFigureOut">
              <a:rPr lang="en-GB" smtClean="0"/>
              <a:t>26/02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742DD5-0C0E-43B2-8265-2B3269F610A4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87157093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e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16590944" y="925744"/>
            <a:ext cx="4999018" cy="14735431"/>
          </a:xfrm>
        </p:spPr>
        <p:txBody>
          <a:bodyPr vert="eaVert"/>
          <a:lstStyle/>
          <a:p>
            <a:r>
              <a:rPr lang="pt-PT"/>
              <a:t>Clique para editar o estilo de título do Modelo Global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1593891" y="925744"/>
            <a:ext cx="14707255" cy="14735431"/>
          </a:xfrm>
        </p:spPr>
        <p:txBody>
          <a:bodyPr vert="eaVert"/>
          <a:lstStyle/>
          <a:p>
            <a:pPr lvl="0"/>
            <a:r>
              <a:rPr lang="pt-PT"/>
              <a:t>Clique para editar os estilos do texto de Modelo Global</a:t>
            </a:r>
          </a:p>
          <a:p>
            <a:pPr lvl="1"/>
            <a:r>
              <a:rPr lang="pt-PT"/>
              <a:t>Segundo nível</a:t>
            </a:r>
          </a:p>
          <a:p>
            <a:pPr lvl="2"/>
            <a:r>
              <a:rPr lang="pt-PT"/>
              <a:t>Terceiro nível</a:t>
            </a:r>
          </a:p>
          <a:p>
            <a:pPr lvl="3"/>
            <a:r>
              <a:rPr lang="pt-PT"/>
              <a:t>Quarto nível</a:t>
            </a:r>
          </a:p>
          <a:p>
            <a:pPr lvl="4"/>
            <a:r>
              <a:rPr lang="pt-PT"/>
              <a:t>Quinto ní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A616BE-27E2-40FC-8B61-BDA185EFADEF}" type="datetimeFigureOut">
              <a:rPr lang="en-GB" smtClean="0"/>
              <a:t>26/02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742DD5-0C0E-43B2-8265-2B3269F610A4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2363203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e Obje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PT"/>
              <a:t>Clique para editar o estilo de título do Modelo Global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pt-PT"/>
              <a:t>Clique para editar os estilos do texto de Modelo Global</a:t>
            </a:r>
          </a:p>
          <a:p>
            <a:pPr lvl="1"/>
            <a:r>
              <a:rPr lang="pt-PT"/>
              <a:t>Segundo nível</a:t>
            </a:r>
          </a:p>
          <a:p>
            <a:pPr lvl="2"/>
            <a:r>
              <a:rPr lang="pt-PT"/>
              <a:t>Terceiro nível</a:t>
            </a:r>
          </a:p>
          <a:p>
            <a:pPr lvl="3"/>
            <a:r>
              <a:rPr lang="pt-PT"/>
              <a:t>Quarto nível</a:t>
            </a:r>
          </a:p>
          <a:p>
            <a:pPr lvl="4"/>
            <a:r>
              <a:rPr lang="pt-PT"/>
              <a:t>Quinto ní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A616BE-27E2-40FC-8B61-BDA185EFADEF}" type="datetimeFigureOut">
              <a:rPr lang="en-GB" smtClean="0"/>
              <a:t>26/02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742DD5-0C0E-43B2-8265-2B3269F610A4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8331408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Cabeçalho da Secçã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581816" y="4334902"/>
            <a:ext cx="19996071" cy="7232877"/>
          </a:xfrm>
        </p:spPr>
        <p:txBody>
          <a:bodyPr anchor="b"/>
          <a:lstStyle>
            <a:lvl1pPr>
              <a:defRPr sz="15212"/>
            </a:lvl1pPr>
          </a:lstStyle>
          <a:p>
            <a:r>
              <a:rPr lang="pt-PT"/>
              <a:t>Clique para editar o estilo de título do Modelo Global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581816" y="11636205"/>
            <a:ext cx="19996071" cy="3803599"/>
          </a:xfrm>
        </p:spPr>
        <p:txBody>
          <a:bodyPr/>
          <a:lstStyle>
            <a:lvl1pPr marL="0" indent="0">
              <a:buNone/>
              <a:defRPr sz="6085">
                <a:solidFill>
                  <a:schemeClr val="tx1"/>
                </a:solidFill>
              </a:defRPr>
            </a:lvl1pPr>
            <a:lvl2pPr marL="1159185" indent="0">
              <a:buNone/>
              <a:defRPr sz="5071">
                <a:solidFill>
                  <a:schemeClr val="tx1">
                    <a:tint val="75000"/>
                  </a:schemeClr>
                </a:solidFill>
              </a:defRPr>
            </a:lvl2pPr>
            <a:lvl3pPr marL="2318370" indent="0">
              <a:buNone/>
              <a:defRPr sz="4564">
                <a:solidFill>
                  <a:schemeClr val="tx1">
                    <a:tint val="75000"/>
                  </a:schemeClr>
                </a:solidFill>
              </a:defRPr>
            </a:lvl3pPr>
            <a:lvl4pPr marL="3477555" indent="0">
              <a:buNone/>
              <a:defRPr sz="4057">
                <a:solidFill>
                  <a:schemeClr val="tx1">
                    <a:tint val="75000"/>
                  </a:schemeClr>
                </a:solidFill>
              </a:defRPr>
            </a:lvl4pPr>
            <a:lvl5pPr marL="4636740" indent="0">
              <a:buNone/>
              <a:defRPr sz="4057">
                <a:solidFill>
                  <a:schemeClr val="tx1">
                    <a:tint val="75000"/>
                  </a:schemeClr>
                </a:solidFill>
              </a:defRPr>
            </a:lvl5pPr>
            <a:lvl6pPr marL="5795924" indent="0">
              <a:buNone/>
              <a:defRPr sz="4057">
                <a:solidFill>
                  <a:schemeClr val="tx1">
                    <a:tint val="75000"/>
                  </a:schemeClr>
                </a:solidFill>
              </a:defRPr>
            </a:lvl6pPr>
            <a:lvl7pPr marL="6955109" indent="0">
              <a:buNone/>
              <a:defRPr sz="4057">
                <a:solidFill>
                  <a:schemeClr val="tx1">
                    <a:tint val="75000"/>
                  </a:schemeClr>
                </a:solidFill>
              </a:defRPr>
            </a:lvl7pPr>
            <a:lvl8pPr marL="8114294" indent="0">
              <a:buNone/>
              <a:defRPr sz="4057">
                <a:solidFill>
                  <a:schemeClr val="tx1">
                    <a:tint val="75000"/>
                  </a:schemeClr>
                </a:solidFill>
              </a:defRPr>
            </a:lvl8pPr>
            <a:lvl9pPr marL="9273479" indent="0">
              <a:buNone/>
              <a:defRPr sz="4057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pt-PT"/>
              <a:t>Clique para editar os estilos do texto de Modelo Globa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A616BE-27E2-40FC-8B61-BDA185EFADEF}" type="datetimeFigureOut">
              <a:rPr lang="en-GB" smtClean="0"/>
              <a:t>26/02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742DD5-0C0E-43B2-8265-2B3269F610A4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23198719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Conteúdo Dup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PT"/>
              <a:t>Clique para editar o estilo de título do Modelo Global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1593890" y="4628720"/>
            <a:ext cx="9853136" cy="11032455"/>
          </a:xfrm>
        </p:spPr>
        <p:txBody>
          <a:bodyPr/>
          <a:lstStyle/>
          <a:p>
            <a:pPr lvl="0"/>
            <a:r>
              <a:rPr lang="pt-PT"/>
              <a:t>Clique para editar os estilos do texto de Modelo Global</a:t>
            </a:r>
          </a:p>
          <a:p>
            <a:pPr lvl="1"/>
            <a:r>
              <a:rPr lang="pt-PT"/>
              <a:t>Segundo nível</a:t>
            </a:r>
          </a:p>
          <a:p>
            <a:pPr lvl="2"/>
            <a:r>
              <a:rPr lang="pt-PT"/>
              <a:t>Terceiro nível</a:t>
            </a:r>
          </a:p>
          <a:p>
            <a:pPr lvl="3"/>
            <a:r>
              <a:rPr lang="pt-PT"/>
              <a:t>Quarto nível</a:t>
            </a:r>
          </a:p>
          <a:p>
            <a:pPr lvl="4"/>
            <a:r>
              <a:rPr lang="pt-PT"/>
              <a:t>Quinto ní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11736824" y="4628720"/>
            <a:ext cx="9853136" cy="11032455"/>
          </a:xfrm>
        </p:spPr>
        <p:txBody>
          <a:bodyPr/>
          <a:lstStyle/>
          <a:p>
            <a:pPr lvl="0"/>
            <a:r>
              <a:rPr lang="pt-PT"/>
              <a:t>Clique para editar os estilos do texto de Modelo Global</a:t>
            </a:r>
          </a:p>
          <a:p>
            <a:pPr lvl="1"/>
            <a:r>
              <a:rPr lang="pt-PT"/>
              <a:t>Segundo nível</a:t>
            </a:r>
          </a:p>
          <a:p>
            <a:pPr lvl="2"/>
            <a:r>
              <a:rPr lang="pt-PT"/>
              <a:t>Terceiro nível</a:t>
            </a:r>
          </a:p>
          <a:p>
            <a:pPr lvl="3"/>
            <a:r>
              <a:rPr lang="pt-PT"/>
              <a:t>Quarto nível</a:t>
            </a:r>
          </a:p>
          <a:p>
            <a:pPr lvl="4"/>
            <a:r>
              <a:rPr lang="pt-PT"/>
              <a:t>Quinto ní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A616BE-27E2-40FC-8B61-BDA185EFADEF}" type="datetimeFigureOut">
              <a:rPr lang="en-GB" smtClean="0"/>
              <a:t>26/02/2021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742DD5-0C0E-43B2-8265-2B3269F610A4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88754645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çã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596909" y="925748"/>
            <a:ext cx="19996071" cy="3360855"/>
          </a:xfrm>
        </p:spPr>
        <p:txBody>
          <a:bodyPr/>
          <a:lstStyle/>
          <a:p>
            <a:r>
              <a:rPr lang="pt-PT"/>
              <a:t>Clique para editar o estilo de título do Modelo Global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596912" y="4262449"/>
            <a:ext cx="9807854" cy="2088960"/>
          </a:xfrm>
        </p:spPr>
        <p:txBody>
          <a:bodyPr anchor="b"/>
          <a:lstStyle>
            <a:lvl1pPr marL="0" indent="0">
              <a:buNone/>
              <a:defRPr sz="6085" b="1"/>
            </a:lvl1pPr>
            <a:lvl2pPr marL="1159185" indent="0">
              <a:buNone/>
              <a:defRPr sz="5071" b="1"/>
            </a:lvl2pPr>
            <a:lvl3pPr marL="2318370" indent="0">
              <a:buNone/>
              <a:defRPr sz="4564" b="1"/>
            </a:lvl3pPr>
            <a:lvl4pPr marL="3477555" indent="0">
              <a:buNone/>
              <a:defRPr sz="4057" b="1"/>
            </a:lvl4pPr>
            <a:lvl5pPr marL="4636740" indent="0">
              <a:buNone/>
              <a:defRPr sz="4057" b="1"/>
            </a:lvl5pPr>
            <a:lvl6pPr marL="5795924" indent="0">
              <a:buNone/>
              <a:defRPr sz="4057" b="1"/>
            </a:lvl6pPr>
            <a:lvl7pPr marL="6955109" indent="0">
              <a:buNone/>
              <a:defRPr sz="4057" b="1"/>
            </a:lvl7pPr>
            <a:lvl8pPr marL="8114294" indent="0">
              <a:buNone/>
              <a:defRPr sz="4057" b="1"/>
            </a:lvl8pPr>
            <a:lvl9pPr marL="9273479" indent="0">
              <a:buNone/>
              <a:defRPr sz="4057" b="1"/>
            </a:lvl9pPr>
          </a:lstStyle>
          <a:p>
            <a:pPr lvl="0"/>
            <a:r>
              <a:rPr lang="pt-PT"/>
              <a:t>Clique para editar os estilos do texto de Modelo Globa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1596912" y="6351409"/>
            <a:ext cx="9807854" cy="9341966"/>
          </a:xfrm>
        </p:spPr>
        <p:txBody>
          <a:bodyPr/>
          <a:lstStyle/>
          <a:p>
            <a:pPr lvl="0"/>
            <a:r>
              <a:rPr lang="pt-PT"/>
              <a:t>Clique para editar os estilos do texto de Modelo Global</a:t>
            </a:r>
          </a:p>
          <a:p>
            <a:pPr lvl="1"/>
            <a:r>
              <a:rPr lang="pt-PT"/>
              <a:t>Segundo nível</a:t>
            </a:r>
          </a:p>
          <a:p>
            <a:pPr lvl="2"/>
            <a:r>
              <a:rPr lang="pt-PT"/>
              <a:t>Terceiro nível</a:t>
            </a:r>
          </a:p>
          <a:p>
            <a:pPr lvl="3"/>
            <a:r>
              <a:rPr lang="pt-PT"/>
              <a:t>Quarto nível</a:t>
            </a:r>
          </a:p>
          <a:p>
            <a:pPr lvl="4"/>
            <a:r>
              <a:rPr lang="pt-PT"/>
              <a:t>Quinto ní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11736825" y="4262449"/>
            <a:ext cx="9856156" cy="2088960"/>
          </a:xfrm>
        </p:spPr>
        <p:txBody>
          <a:bodyPr anchor="b"/>
          <a:lstStyle>
            <a:lvl1pPr marL="0" indent="0">
              <a:buNone/>
              <a:defRPr sz="6085" b="1"/>
            </a:lvl1pPr>
            <a:lvl2pPr marL="1159185" indent="0">
              <a:buNone/>
              <a:defRPr sz="5071" b="1"/>
            </a:lvl2pPr>
            <a:lvl3pPr marL="2318370" indent="0">
              <a:buNone/>
              <a:defRPr sz="4564" b="1"/>
            </a:lvl3pPr>
            <a:lvl4pPr marL="3477555" indent="0">
              <a:buNone/>
              <a:defRPr sz="4057" b="1"/>
            </a:lvl4pPr>
            <a:lvl5pPr marL="4636740" indent="0">
              <a:buNone/>
              <a:defRPr sz="4057" b="1"/>
            </a:lvl5pPr>
            <a:lvl6pPr marL="5795924" indent="0">
              <a:buNone/>
              <a:defRPr sz="4057" b="1"/>
            </a:lvl6pPr>
            <a:lvl7pPr marL="6955109" indent="0">
              <a:buNone/>
              <a:defRPr sz="4057" b="1"/>
            </a:lvl7pPr>
            <a:lvl8pPr marL="8114294" indent="0">
              <a:buNone/>
              <a:defRPr sz="4057" b="1"/>
            </a:lvl8pPr>
            <a:lvl9pPr marL="9273479" indent="0">
              <a:buNone/>
              <a:defRPr sz="4057" b="1"/>
            </a:lvl9pPr>
          </a:lstStyle>
          <a:p>
            <a:pPr lvl="0"/>
            <a:r>
              <a:rPr lang="pt-PT"/>
              <a:t>Clique para editar os estilos do texto de Modelo Global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11736825" y="6351409"/>
            <a:ext cx="9856156" cy="9341966"/>
          </a:xfrm>
        </p:spPr>
        <p:txBody>
          <a:bodyPr/>
          <a:lstStyle/>
          <a:p>
            <a:pPr lvl="0"/>
            <a:r>
              <a:rPr lang="pt-PT"/>
              <a:t>Clique para editar os estilos do texto de Modelo Global</a:t>
            </a:r>
          </a:p>
          <a:p>
            <a:pPr lvl="1"/>
            <a:r>
              <a:rPr lang="pt-PT"/>
              <a:t>Segundo nível</a:t>
            </a:r>
          </a:p>
          <a:p>
            <a:pPr lvl="2"/>
            <a:r>
              <a:rPr lang="pt-PT"/>
              <a:t>Terceiro nível</a:t>
            </a:r>
          </a:p>
          <a:p>
            <a:pPr lvl="3"/>
            <a:r>
              <a:rPr lang="pt-PT"/>
              <a:t>Quarto nível</a:t>
            </a:r>
          </a:p>
          <a:p>
            <a:pPr lvl="4"/>
            <a:r>
              <a:rPr lang="pt-PT"/>
              <a:t>Quinto ní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A616BE-27E2-40FC-8B61-BDA185EFADEF}" type="datetimeFigureOut">
              <a:rPr lang="en-GB" smtClean="0"/>
              <a:t>26/02/2021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742DD5-0C0E-43B2-8265-2B3269F610A4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56087843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ó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PT"/>
              <a:t>Clique para editar o estilo de título do Modelo Global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A616BE-27E2-40FC-8B61-BDA185EFADEF}" type="datetimeFigureOut">
              <a:rPr lang="en-GB" smtClean="0"/>
              <a:t>26/02/2021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742DD5-0C0E-43B2-8265-2B3269F610A4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1387523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m br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A616BE-27E2-40FC-8B61-BDA185EFADEF}" type="datetimeFigureOut">
              <a:rPr lang="en-GB" smtClean="0"/>
              <a:t>26/02/2021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742DD5-0C0E-43B2-8265-2B3269F610A4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3349195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údo com Legend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596909" y="1159192"/>
            <a:ext cx="7477395" cy="4057174"/>
          </a:xfrm>
        </p:spPr>
        <p:txBody>
          <a:bodyPr anchor="b"/>
          <a:lstStyle>
            <a:lvl1pPr>
              <a:defRPr sz="8113"/>
            </a:lvl1pPr>
          </a:lstStyle>
          <a:p>
            <a:r>
              <a:rPr lang="pt-PT"/>
              <a:t>Clique para editar o estilo de título do Modelo Global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9856156" y="2503538"/>
            <a:ext cx="11736824" cy="12356670"/>
          </a:xfrm>
        </p:spPr>
        <p:txBody>
          <a:bodyPr/>
          <a:lstStyle>
            <a:lvl1pPr>
              <a:defRPr sz="8113"/>
            </a:lvl1pPr>
            <a:lvl2pPr>
              <a:defRPr sz="7099"/>
            </a:lvl2pPr>
            <a:lvl3pPr>
              <a:defRPr sz="6085"/>
            </a:lvl3pPr>
            <a:lvl4pPr>
              <a:defRPr sz="5071"/>
            </a:lvl4pPr>
            <a:lvl5pPr>
              <a:defRPr sz="5071"/>
            </a:lvl5pPr>
            <a:lvl6pPr>
              <a:defRPr sz="5071"/>
            </a:lvl6pPr>
            <a:lvl7pPr>
              <a:defRPr sz="5071"/>
            </a:lvl7pPr>
            <a:lvl8pPr>
              <a:defRPr sz="5071"/>
            </a:lvl8pPr>
            <a:lvl9pPr>
              <a:defRPr sz="5071"/>
            </a:lvl9pPr>
          </a:lstStyle>
          <a:p>
            <a:pPr lvl="0"/>
            <a:r>
              <a:rPr lang="pt-PT"/>
              <a:t>Clique para editar os estilos do texto de Modelo Global</a:t>
            </a:r>
          </a:p>
          <a:p>
            <a:pPr lvl="1"/>
            <a:r>
              <a:rPr lang="pt-PT"/>
              <a:t>Segundo nível</a:t>
            </a:r>
          </a:p>
          <a:p>
            <a:pPr lvl="2"/>
            <a:r>
              <a:rPr lang="pt-PT"/>
              <a:t>Terceiro nível</a:t>
            </a:r>
          </a:p>
          <a:p>
            <a:pPr lvl="3"/>
            <a:r>
              <a:rPr lang="pt-PT"/>
              <a:t>Quarto nível</a:t>
            </a:r>
          </a:p>
          <a:p>
            <a:pPr lvl="4"/>
            <a:r>
              <a:rPr lang="pt-PT"/>
              <a:t>Quinto ní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596909" y="5216366"/>
            <a:ext cx="7477395" cy="9663964"/>
          </a:xfrm>
        </p:spPr>
        <p:txBody>
          <a:bodyPr/>
          <a:lstStyle>
            <a:lvl1pPr marL="0" indent="0">
              <a:buNone/>
              <a:defRPr sz="4057"/>
            </a:lvl1pPr>
            <a:lvl2pPr marL="1159185" indent="0">
              <a:buNone/>
              <a:defRPr sz="3550"/>
            </a:lvl2pPr>
            <a:lvl3pPr marL="2318370" indent="0">
              <a:buNone/>
              <a:defRPr sz="3042"/>
            </a:lvl3pPr>
            <a:lvl4pPr marL="3477555" indent="0">
              <a:buNone/>
              <a:defRPr sz="2535"/>
            </a:lvl4pPr>
            <a:lvl5pPr marL="4636740" indent="0">
              <a:buNone/>
              <a:defRPr sz="2535"/>
            </a:lvl5pPr>
            <a:lvl6pPr marL="5795924" indent="0">
              <a:buNone/>
              <a:defRPr sz="2535"/>
            </a:lvl6pPr>
            <a:lvl7pPr marL="6955109" indent="0">
              <a:buNone/>
              <a:defRPr sz="2535"/>
            </a:lvl7pPr>
            <a:lvl8pPr marL="8114294" indent="0">
              <a:buNone/>
              <a:defRPr sz="2535"/>
            </a:lvl8pPr>
            <a:lvl9pPr marL="9273479" indent="0">
              <a:buNone/>
              <a:defRPr sz="2535"/>
            </a:lvl9pPr>
          </a:lstStyle>
          <a:p>
            <a:pPr lvl="0"/>
            <a:r>
              <a:rPr lang="pt-PT"/>
              <a:t>Clique para editar os estilos do texto de Modelo Globa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A616BE-27E2-40FC-8B61-BDA185EFADEF}" type="datetimeFigureOut">
              <a:rPr lang="en-GB" smtClean="0"/>
              <a:t>26/02/2021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742DD5-0C0E-43B2-8265-2B3269F610A4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4282937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m com Legend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596909" y="1159192"/>
            <a:ext cx="7477395" cy="4057174"/>
          </a:xfrm>
        </p:spPr>
        <p:txBody>
          <a:bodyPr anchor="b"/>
          <a:lstStyle>
            <a:lvl1pPr>
              <a:defRPr sz="8113"/>
            </a:lvl1pPr>
          </a:lstStyle>
          <a:p>
            <a:r>
              <a:rPr lang="pt-PT"/>
              <a:t>Clique para editar o estilo de título do Modelo Global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9856156" y="2503538"/>
            <a:ext cx="11736824" cy="12356670"/>
          </a:xfrm>
        </p:spPr>
        <p:txBody>
          <a:bodyPr anchor="t"/>
          <a:lstStyle>
            <a:lvl1pPr marL="0" indent="0">
              <a:buNone/>
              <a:defRPr sz="8113"/>
            </a:lvl1pPr>
            <a:lvl2pPr marL="1159185" indent="0">
              <a:buNone/>
              <a:defRPr sz="7099"/>
            </a:lvl2pPr>
            <a:lvl3pPr marL="2318370" indent="0">
              <a:buNone/>
              <a:defRPr sz="6085"/>
            </a:lvl3pPr>
            <a:lvl4pPr marL="3477555" indent="0">
              <a:buNone/>
              <a:defRPr sz="5071"/>
            </a:lvl4pPr>
            <a:lvl5pPr marL="4636740" indent="0">
              <a:buNone/>
              <a:defRPr sz="5071"/>
            </a:lvl5pPr>
            <a:lvl6pPr marL="5795924" indent="0">
              <a:buNone/>
              <a:defRPr sz="5071"/>
            </a:lvl6pPr>
            <a:lvl7pPr marL="6955109" indent="0">
              <a:buNone/>
              <a:defRPr sz="5071"/>
            </a:lvl7pPr>
            <a:lvl8pPr marL="8114294" indent="0">
              <a:buNone/>
              <a:defRPr sz="5071"/>
            </a:lvl8pPr>
            <a:lvl9pPr marL="9273479" indent="0">
              <a:buNone/>
              <a:defRPr sz="5071"/>
            </a:lvl9pPr>
          </a:lstStyle>
          <a:p>
            <a:r>
              <a:rPr lang="pt-PT"/>
              <a:t>Clique no ícone para adicionar uma imagem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596909" y="5216366"/>
            <a:ext cx="7477395" cy="9663964"/>
          </a:xfrm>
        </p:spPr>
        <p:txBody>
          <a:bodyPr/>
          <a:lstStyle>
            <a:lvl1pPr marL="0" indent="0">
              <a:buNone/>
              <a:defRPr sz="4057"/>
            </a:lvl1pPr>
            <a:lvl2pPr marL="1159185" indent="0">
              <a:buNone/>
              <a:defRPr sz="3550"/>
            </a:lvl2pPr>
            <a:lvl3pPr marL="2318370" indent="0">
              <a:buNone/>
              <a:defRPr sz="3042"/>
            </a:lvl3pPr>
            <a:lvl4pPr marL="3477555" indent="0">
              <a:buNone/>
              <a:defRPr sz="2535"/>
            </a:lvl4pPr>
            <a:lvl5pPr marL="4636740" indent="0">
              <a:buNone/>
              <a:defRPr sz="2535"/>
            </a:lvl5pPr>
            <a:lvl6pPr marL="5795924" indent="0">
              <a:buNone/>
              <a:defRPr sz="2535"/>
            </a:lvl6pPr>
            <a:lvl7pPr marL="6955109" indent="0">
              <a:buNone/>
              <a:defRPr sz="2535"/>
            </a:lvl7pPr>
            <a:lvl8pPr marL="8114294" indent="0">
              <a:buNone/>
              <a:defRPr sz="2535"/>
            </a:lvl8pPr>
            <a:lvl9pPr marL="9273479" indent="0">
              <a:buNone/>
              <a:defRPr sz="2535"/>
            </a:lvl9pPr>
          </a:lstStyle>
          <a:p>
            <a:pPr lvl="0"/>
            <a:r>
              <a:rPr lang="pt-PT"/>
              <a:t>Clique para editar os estilos do texto de Modelo Globa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A616BE-27E2-40FC-8B61-BDA185EFADEF}" type="datetimeFigureOut">
              <a:rPr lang="en-GB" smtClean="0"/>
              <a:t>26/02/2021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742DD5-0C0E-43B2-8265-2B3269F610A4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2037267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1593890" y="925748"/>
            <a:ext cx="19996071" cy="3360855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pt-PT"/>
              <a:t>Clique para editar o estilo de título do Modelo Global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593890" y="4628720"/>
            <a:ext cx="19996071" cy="11032455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pt-PT"/>
              <a:t>Clique para editar os estilos do texto de Modelo Global</a:t>
            </a:r>
          </a:p>
          <a:p>
            <a:pPr lvl="1"/>
            <a:r>
              <a:rPr lang="pt-PT"/>
              <a:t>Segundo nível</a:t>
            </a:r>
          </a:p>
          <a:p>
            <a:pPr lvl="2"/>
            <a:r>
              <a:rPr lang="pt-PT"/>
              <a:t>Terceiro nível</a:t>
            </a:r>
          </a:p>
          <a:p>
            <a:pPr lvl="3"/>
            <a:r>
              <a:rPr lang="pt-PT"/>
              <a:t>Quarto nível</a:t>
            </a:r>
          </a:p>
          <a:p>
            <a:pPr lvl="4"/>
            <a:r>
              <a:rPr lang="pt-PT"/>
              <a:t>Quinto ní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1593890" y="16116000"/>
            <a:ext cx="5216366" cy="925744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304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5A616BE-27E2-40FC-8B61-BDA185EFADEF}" type="datetimeFigureOut">
              <a:rPr lang="en-GB" smtClean="0"/>
              <a:t>26/02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7679651" y="16116000"/>
            <a:ext cx="7824549" cy="925744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304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6373594" y="16116000"/>
            <a:ext cx="5216366" cy="925744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304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A742DD5-0C0E-43B2-8265-2B3269F610A4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89789230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733" r:id="rId1"/>
    <p:sldLayoutId id="2147483734" r:id="rId2"/>
    <p:sldLayoutId id="2147483735" r:id="rId3"/>
    <p:sldLayoutId id="2147483736" r:id="rId4"/>
    <p:sldLayoutId id="2147483737" r:id="rId5"/>
    <p:sldLayoutId id="2147483738" r:id="rId6"/>
    <p:sldLayoutId id="2147483739" r:id="rId7"/>
    <p:sldLayoutId id="2147483740" r:id="rId8"/>
    <p:sldLayoutId id="2147483741" r:id="rId9"/>
    <p:sldLayoutId id="2147483742" r:id="rId10"/>
    <p:sldLayoutId id="2147483743" r:id="rId11"/>
  </p:sldLayoutIdLst>
  <p:txStyles>
    <p:titleStyle>
      <a:lvl1pPr algn="l" defTabSz="2318370" rtl="0" eaLnBrk="1" latinLnBrk="0" hangingPunct="1">
        <a:lnSpc>
          <a:spcPct val="90000"/>
        </a:lnSpc>
        <a:spcBef>
          <a:spcPct val="0"/>
        </a:spcBef>
        <a:buNone/>
        <a:defRPr sz="11156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579592" indent="-579592" algn="l" defTabSz="2318370" rtl="0" eaLnBrk="1" latinLnBrk="0" hangingPunct="1">
        <a:lnSpc>
          <a:spcPct val="90000"/>
        </a:lnSpc>
        <a:spcBef>
          <a:spcPts val="2535"/>
        </a:spcBef>
        <a:buFont typeface="Arial" panose="020B0604020202020204" pitchFamily="34" charset="0"/>
        <a:buChar char="•"/>
        <a:defRPr sz="7099" kern="1200">
          <a:solidFill>
            <a:schemeClr val="tx1"/>
          </a:solidFill>
          <a:latin typeface="+mn-lt"/>
          <a:ea typeface="+mn-ea"/>
          <a:cs typeface="+mn-cs"/>
        </a:defRPr>
      </a:lvl1pPr>
      <a:lvl2pPr marL="1738777" indent="-579592" algn="l" defTabSz="2318370" rtl="0" eaLnBrk="1" latinLnBrk="0" hangingPunct="1">
        <a:lnSpc>
          <a:spcPct val="90000"/>
        </a:lnSpc>
        <a:spcBef>
          <a:spcPts val="1268"/>
        </a:spcBef>
        <a:buFont typeface="Arial" panose="020B0604020202020204" pitchFamily="34" charset="0"/>
        <a:buChar char="•"/>
        <a:defRPr sz="6085" kern="1200">
          <a:solidFill>
            <a:schemeClr val="tx1"/>
          </a:solidFill>
          <a:latin typeface="+mn-lt"/>
          <a:ea typeface="+mn-ea"/>
          <a:cs typeface="+mn-cs"/>
        </a:defRPr>
      </a:lvl2pPr>
      <a:lvl3pPr marL="2897962" indent="-579592" algn="l" defTabSz="2318370" rtl="0" eaLnBrk="1" latinLnBrk="0" hangingPunct="1">
        <a:lnSpc>
          <a:spcPct val="90000"/>
        </a:lnSpc>
        <a:spcBef>
          <a:spcPts val="1268"/>
        </a:spcBef>
        <a:buFont typeface="Arial" panose="020B0604020202020204" pitchFamily="34" charset="0"/>
        <a:buChar char="•"/>
        <a:defRPr sz="5071" kern="1200">
          <a:solidFill>
            <a:schemeClr val="tx1"/>
          </a:solidFill>
          <a:latin typeface="+mn-lt"/>
          <a:ea typeface="+mn-ea"/>
          <a:cs typeface="+mn-cs"/>
        </a:defRPr>
      </a:lvl3pPr>
      <a:lvl4pPr marL="4057147" indent="-579592" algn="l" defTabSz="2318370" rtl="0" eaLnBrk="1" latinLnBrk="0" hangingPunct="1">
        <a:lnSpc>
          <a:spcPct val="90000"/>
        </a:lnSpc>
        <a:spcBef>
          <a:spcPts val="1268"/>
        </a:spcBef>
        <a:buFont typeface="Arial" panose="020B0604020202020204" pitchFamily="34" charset="0"/>
        <a:buChar char="•"/>
        <a:defRPr sz="4564" kern="1200">
          <a:solidFill>
            <a:schemeClr val="tx1"/>
          </a:solidFill>
          <a:latin typeface="+mn-lt"/>
          <a:ea typeface="+mn-ea"/>
          <a:cs typeface="+mn-cs"/>
        </a:defRPr>
      </a:lvl4pPr>
      <a:lvl5pPr marL="5216332" indent="-579592" algn="l" defTabSz="2318370" rtl="0" eaLnBrk="1" latinLnBrk="0" hangingPunct="1">
        <a:lnSpc>
          <a:spcPct val="90000"/>
        </a:lnSpc>
        <a:spcBef>
          <a:spcPts val="1268"/>
        </a:spcBef>
        <a:buFont typeface="Arial" panose="020B0604020202020204" pitchFamily="34" charset="0"/>
        <a:buChar char="•"/>
        <a:defRPr sz="4564" kern="1200">
          <a:solidFill>
            <a:schemeClr val="tx1"/>
          </a:solidFill>
          <a:latin typeface="+mn-lt"/>
          <a:ea typeface="+mn-ea"/>
          <a:cs typeface="+mn-cs"/>
        </a:defRPr>
      </a:lvl5pPr>
      <a:lvl6pPr marL="6375517" indent="-579592" algn="l" defTabSz="2318370" rtl="0" eaLnBrk="1" latinLnBrk="0" hangingPunct="1">
        <a:lnSpc>
          <a:spcPct val="90000"/>
        </a:lnSpc>
        <a:spcBef>
          <a:spcPts val="1268"/>
        </a:spcBef>
        <a:buFont typeface="Arial" panose="020B0604020202020204" pitchFamily="34" charset="0"/>
        <a:buChar char="•"/>
        <a:defRPr sz="4564" kern="1200">
          <a:solidFill>
            <a:schemeClr val="tx1"/>
          </a:solidFill>
          <a:latin typeface="+mn-lt"/>
          <a:ea typeface="+mn-ea"/>
          <a:cs typeface="+mn-cs"/>
        </a:defRPr>
      </a:lvl6pPr>
      <a:lvl7pPr marL="7534702" indent="-579592" algn="l" defTabSz="2318370" rtl="0" eaLnBrk="1" latinLnBrk="0" hangingPunct="1">
        <a:lnSpc>
          <a:spcPct val="90000"/>
        </a:lnSpc>
        <a:spcBef>
          <a:spcPts val="1268"/>
        </a:spcBef>
        <a:buFont typeface="Arial" panose="020B0604020202020204" pitchFamily="34" charset="0"/>
        <a:buChar char="•"/>
        <a:defRPr sz="4564" kern="1200">
          <a:solidFill>
            <a:schemeClr val="tx1"/>
          </a:solidFill>
          <a:latin typeface="+mn-lt"/>
          <a:ea typeface="+mn-ea"/>
          <a:cs typeface="+mn-cs"/>
        </a:defRPr>
      </a:lvl7pPr>
      <a:lvl8pPr marL="8693887" indent="-579592" algn="l" defTabSz="2318370" rtl="0" eaLnBrk="1" latinLnBrk="0" hangingPunct="1">
        <a:lnSpc>
          <a:spcPct val="90000"/>
        </a:lnSpc>
        <a:spcBef>
          <a:spcPts val="1268"/>
        </a:spcBef>
        <a:buFont typeface="Arial" panose="020B0604020202020204" pitchFamily="34" charset="0"/>
        <a:buChar char="•"/>
        <a:defRPr sz="4564" kern="1200">
          <a:solidFill>
            <a:schemeClr val="tx1"/>
          </a:solidFill>
          <a:latin typeface="+mn-lt"/>
          <a:ea typeface="+mn-ea"/>
          <a:cs typeface="+mn-cs"/>
        </a:defRPr>
      </a:lvl8pPr>
      <a:lvl9pPr marL="9853071" indent="-579592" algn="l" defTabSz="2318370" rtl="0" eaLnBrk="1" latinLnBrk="0" hangingPunct="1">
        <a:lnSpc>
          <a:spcPct val="90000"/>
        </a:lnSpc>
        <a:spcBef>
          <a:spcPts val="1268"/>
        </a:spcBef>
        <a:buFont typeface="Arial" panose="020B0604020202020204" pitchFamily="34" charset="0"/>
        <a:buChar char="•"/>
        <a:defRPr sz="4564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2318370" rtl="0" eaLnBrk="1" latinLnBrk="0" hangingPunct="1">
        <a:defRPr sz="4564" kern="1200">
          <a:solidFill>
            <a:schemeClr val="tx1"/>
          </a:solidFill>
          <a:latin typeface="+mn-lt"/>
          <a:ea typeface="+mn-ea"/>
          <a:cs typeface="+mn-cs"/>
        </a:defRPr>
      </a:lvl1pPr>
      <a:lvl2pPr marL="1159185" algn="l" defTabSz="2318370" rtl="0" eaLnBrk="1" latinLnBrk="0" hangingPunct="1">
        <a:defRPr sz="4564" kern="1200">
          <a:solidFill>
            <a:schemeClr val="tx1"/>
          </a:solidFill>
          <a:latin typeface="+mn-lt"/>
          <a:ea typeface="+mn-ea"/>
          <a:cs typeface="+mn-cs"/>
        </a:defRPr>
      </a:lvl2pPr>
      <a:lvl3pPr marL="2318370" algn="l" defTabSz="2318370" rtl="0" eaLnBrk="1" latinLnBrk="0" hangingPunct="1">
        <a:defRPr sz="4564" kern="1200">
          <a:solidFill>
            <a:schemeClr val="tx1"/>
          </a:solidFill>
          <a:latin typeface="+mn-lt"/>
          <a:ea typeface="+mn-ea"/>
          <a:cs typeface="+mn-cs"/>
        </a:defRPr>
      </a:lvl3pPr>
      <a:lvl4pPr marL="3477555" algn="l" defTabSz="2318370" rtl="0" eaLnBrk="1" latinLnBrk="0" hangingPunct="1">
        <a:defRPr sz="4564" kern="1200">
          <a:solidFill>
            <a:schemeClr val="tx1"/>
          </a:solidFill>
          <a:latin typeface="+mn-lt"/>
          <a:ea typeface="+mn-ea"/>
          <a:cs typeface="+mn-cs"/>
        </a:defRPr>
      </a:lvl4pPr>
      <a:lvl5pPr marL="4636740" algn="l" defTabSz="2318370" rtl="0" eaLnBrk="1" latinLnBrk="0" hangingPunct="1">
        <a:defRPr sz="4564" kern="1200">
          <a:solidFill>
            <a:schemeClr val="tx1"/>
          </a:solidFill>
          <a:latin typeface="+mn-lt"/>
          <a:ea typeface="+mn-ea"/>
          <a:cs typeface="+mn-cs"/>
        </a:defRPr>
      </a:lvl5pPr>
      <a:lvl6pPr marL="5795924" algn="l" defTabSz="2318370" rtl="0" eaLnBrk="1" latinLnBrk="0" hangingPunct="1">
        <a:defRPr sz="4564" kern="1200">
          <a:solidFill>
            <a:schemeClr val="tx1"/>
          </a:solidFill>
          <a:latin typeface="+mn-lt"/>
          <a:ea typeface="+mn-ea"/>
          <a:cs typeface="+mn-cs"/>
        </a:defRPr>
      </a:lvl6pPr>
      <a:lvl7pPr marL="6955109" algn="l" defTabSz="2318370" rtl="0" eaLnBrk="1" latinLnBrk="0" hangingPunct="1">
        <a:defRPr sz="4564" kern="1200">
          <a:solidFill>
            <a:schemeClr val="tx1"/>
          </a:solidFill>
          <a:latin typeface="+mn-lt"/>
          <a:ea typeface="+mn-ea"/>
          <a:cs typeface="+mn-cs"/>
        </a:defRPr>
      </a:lvl7pPr>
      <a:lvl8pPr marL="8114294" algn="l" defTabSz="2318370" rtl="0" eaLnBrk="1" latinLnBrk="0" hangingPunct="1">
        <a:defRPr sz="4564" kern="1200">
          <a:solidFill>
            <a:schemeClr val="tx1"/>
          </a:solidFill>
          <a:latin typeface="+mn-lt"/>
          <a:ea typeface="+mn-ea"/>
          <a:cs typeface="+mn-cs"/>
        </a:defRPr>
      </a:lvl8pPr>
      <a:lvl9pPr marL="9273479" algn="l" defTabSz="2318370" rtl="0" eaLnBrk="1" latinLnBrk="0" hangingPunct="1">
        <a:defRPr sz="4564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7" name="Agrupar 6">
            <a:extLst>
              <a:ext uri="{FF2B5EF4-FFF2-40B4-BE49-F238E27FC236}">
                <a16:creationId xmlns:a16="http://schemas.microsoft.com/office/drawing/2014/main" id="{E903ED90-3A7A-4590-AF05-5EC6BAF46743}"/>
              </a:ext>
            </a:extLst>
          </p:cNvPr>
          <p:cNvGrpSpPr/>
          <p:nvPr/>
        </p:nvGrpSpPr>
        <p:grpSpPr>
          <a:xfrm>
            <a:off x="3273786" y="683123"/>
            <a:ext cx="17709391" cy="14260216"/>
            <a:chOff x="2792214" y="3025563"/>
            <a:chExt cx="13446962" cy="10827961"/>
          </a:xfrm>
        </p:grpSpPr>
        <p:sp>
          <p:nvSpPr>
            <p:cNvPr id="23" name="CaixaDeTexto 22">
              <a:extLst>
                <a:ext uri="{FF2B5EF4-FFF2-40B4-BE49-F238E27FC236}">
                  <a16:creationId xmlns:a16="http://schemas.microsoft.com/office/drawing/2014/main" id="{3D6CB9E9-EE5D-476D-8AA0-E8293BE6095D}"/>
                </a:ext>
              </a:extLst>
            </p:cNvPr>
            <p:cNvSpPr txBox="1"/>
            <p:nvPr/>
          </p:nvSpPr>
          <p:spPr>
            <a:xfrm>
              <a:off x="8599608" y="3089555"/>
              <a:ext cx="483358" cy="2240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317" b="1" dirty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</a:p>
          </p:txBody>
        </p:sp>
        <p:grpSp>
          <p:nvGrpSpPr>
            <p:cNvPr id="6" name="Agrupar 5">
              <a:extLst>
                <a:ext uri="{FF2B5EF4-FFF2-40B4-BE49-F238E27FC236}">
                  <a16:creationId xmlns:a16="http://schemas.microsoft.com/office/drawing/2014/main" id="{9CC0E618-384C-4D94-AF8B-BB674AEC3F5B}"/>
                </a:ext>
              </a:extLst>
            </p:cNvPr>
            <p:cNvGrpSpPr/>
            <p:nvPr/>
          </p:nvGrpSpPr>
          <p:grpSpPr>
            <a:xfrm>
              <a:off x="2792214" y="3025563"/>
              <a:ext cx="13446962" cy="10827961"/>
              <a:chOff x="2792214" y="3025563"/>
              <a:chExt cx="13446962" cy="10827961"/>
            </a:xfrm>
          </p:grpSpPr>
          <p:grpSp>
            <p:nvGrpSpPr>
              <p:cNvPr id="2" name="Agrupar 1">
                <a:extLst>
                  <a:ext uri="{FF2B5EF4-FFF2-40B4-BE49-F238E27FC236}">
                    <a16:creationId xmlns:a16="http://schemas.microsoft.com/office/drawing/2014/main" id="{D9B971C6-6D47-4434-B595-4F25BD88A60A}"/>
                  </a:ext>
                </a:extLst>
              </p:cNvPr>
              <p:cNvGrpSpPr/>
              <p:nvPr/>
            </p:nvGrpSpPr>
            <p:grpSpPr>
              <a:xfrm>
                <a:off x="2792214" y="3025563"/>
                <a:ext cx="12832244" cy="10827961"/>
                <a:chOff x="3312618" y="2773212"/>
                <a:chExt cx="12832244" cy="10827961"/>
              </a:xfrm>
            </p:grpSpPr>
            <p:grpSp>
              <p:nvGrpSpPr>
                <p:cNvPr id="9" name="Agrupar 8">
                  <a:extLst>
                    <a:ext uri="{FF2B5EF4-FFF2-40B4-BE49-F238E27FC236}">
                      <a16:creationId xmlns:a16="http://schemas.microsoft.com/office/drawing/2014/main" id="{11D877DD-E5F8-419C-A3DF-ED842070869D}"/>
                    </a:ext>
                  </a:extLst>
                </p:cNvPr>
                <p:cNvGrpSpPr/>
                <p:nvPr/>
              </p:nvGrpSpPr>
              <p:grpSpPr>
                <a:xfrm>
                  <a:off x="3312618" y="2915376"/>
                  <a:ext cx="5600911" cy="6133677"/>
                  <a:chOff x="2282327" y="215039"/>
                  <a:chExt cx="5600911" cy="6133676"/>
                </a:xfrm>
              </p:grpSpPr>
              <p:sp>
                <p:nvSpPr>
                  <p:cNvPr id="4" name="CaixaDeTexto 3">
                    <a:extLst>
                      <a:ext uri="{FF2B5EF4-FFF2-40B4-BE49-F238E27FC236}">
                        <a16:creationId xmlns:a16="http://schemas.microsoft.com/office/drawing/2014/main" id="{E91F4786-F86F-4096-8186-EA26FAD4DBED}"/>
                      </a:ext>
                    </a:extLst>
                  </p:cNvPr>
                  <p:cNvSpPr txBox="1"/>
                  <p:nvPr/>
                </p:nvSpPr>
                <p:spPr>
                  <a:xfrm>
                    <a:off x="2846994" y="215040"/>
                    <a:ext cx="1542084" cy="224010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GB" sz="1317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High adherence</a:t>
                    </a:r>
                  </a:p>
                </p:txBody>
              </p:sp>
              <p:sp>
                <p:nvSpPr>
                  <p:cNvPr id="5" name="CaixaDeTexto 4">
                    <a:extLst>
                      <a:ext uri="{FF2B5EF4-FFF2-40B4-BE49-F238E27FC236}">
                        <a16:creationId xmlns:a16="http://schemas.microsoft.com/office/drawing/2014/main" id="{6CDE75F2-1A60-44E0-90B8-8FCE0541C1B7}"/>
                      </a:ext>
                    </a:extLst>
                  </p:cNvPr>
                  <p:cNvSpPr txBox="1"/>
                  <p:nvPr/>
                </p:nvSpPr>
                <p:spPr>
                  <a:xfrm>
                    <a:off x="4849515" y="215039"/>
                    <a:ext cx="1321119" cy="224010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GB" sz="1317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Low adherence</a:t>
                    </a:r>
                  </a:p>
                </p:txBody>
              </p:sp>
              <p:sp>
                <p:nvSpPr>
                  <p:cNvPr id="10" name="CaixaDeTexto 9">
                    <a:extLst>
                      <a:ext uri="{FF2B5EF4-FFF2-40B4-BE49-F238E27FC236}">
                        <a16:creationId xmlns:a16="http://schemas.microsoft.com/office/drawing/2014/main" id="{EC353C9B-0709-4575-989E-A8613F26C3B0}"/>
                      </a:ext>
                    </a:extLst>
                  </p:cNvPr>
                  <p:cNvSpPr txBox="1"/>
                  <p:nvPr/>
                </p:nvSpPr>
                <p:spPr>
                  <a:xfrm>
                    <a:off x="6360178" y="481308"/>
                    <a:ext cx="1523060" cy="5846117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>
                      <a:spcBef>
                        <a:spcPts val="132"/>
                      </a:spcBef>
                    </a:pPr>
                    <a:r>
                      <a:rPr lang="en-GB" sz="1317" i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Clostridium</a:t>
                    </a:r>
                  </a:p>
                  <a:p>
                    <a:pPr>
                      <a:spcBef>
                        <a:spcPts val="132"/>
                      </a:spcBef>
                    </a:pPr>
                    <a:r>
                      <a:rPr lang="en-GB" sz="1317" i="1" dirty="0" err="1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Coprococcus</a:t>
                    </a:r>
                    <a:endParaRPr lang="en-GB" sz="1317" i="1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  <a:p>
                    <a:pPr>
                      <a:spcBef>
                        <a:spcPts val="132"/>
                      </a:spcBef>
                    </a:pPr>
                    <a:r>
                      <a:rPr lang="en-GB" sz="1317" i="1" dirty="0" err="1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Oscillospira</a:t>
                    </a:r>
                    <a:endParaRPr lang="en-GB" sz="1317" i="1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  <a:p>
                    <a:pPr>
                      <a:spcBef>
                        <a:spcPts val="132"/>
                      </a:spcBef>
                    </a:pPr>
                    <a:r>
                      <a:rPr lang="en-GB" sz="1317" i="1" dirty="0" err="1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Prevotella</a:t>
                    </a:r>
                    <a:endParaRPr lang="en-GB" sz="1317" i="1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  <a:p>
                    <a:pPr>
                      <a:spcBef>
                        <a:spcPts val="132"/>
                      </a:spcBef>
                    </a:pPr>
                    <a:r>
                      <a:rPr lang="en-GB" sz="1317" i="1" dirty="0" err="1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Cellulosibacter</a:t>
                    </a:r>
                    <a:endParaRPr lang="en-GB" sz="1317" i="1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  <a:p>
                    <a:pPr>
                      <a:spcBef>
                        <a:spcPts val="132"/>
                      </a:spcBef>
                    </a:pPr>
                    <a:r>
                      <a:rPr lang="en-GB" sz="1317" i="1" dirty="0" err="1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Faecalibacterium</a:t>
                    </a:r>
                    <a:endParaRPr lang="en-GB" sz="1317" i="1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  <a:p>
                    <a:pPr>
                      <a:spcBef>
                        <a:spcPts val="132"/>
                      </a:spcBef>
                    </a:pPr>
                    <a:r>
                      <a:rPr lang="en-GB" sz="1317" i="1" dirty="0" err="1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Blautia</a:t>
                    </a:r>
                    <a:endParaRPr lang="en-GB" sz="1317" i="1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  <a:p>
                    <a:pPr>
                      <a:spcBef>
                        <a:spcPts val="132"/>
                      </a:spcBef>
                    </a:pPr>
                    <a:r>
                      <a:rPr lang="en-GB" sz="1317" i="1" dirty="0" err="1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Dorea</a:t>
                    </a:r>
                    <a:endParaRPr lang="en-GB" sz="1317" i="1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  <a:p>
                    <a:pPr>
                      <a:spcBef>
                        <a:spcPts val="132"/>
                      </a:spcBef>
                    </a:pPr>
                    <a:r>
                      <a:rPr lang="en-GB" sz="1317" i="1" dirty="0" err="1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Ruminococcus</a:t>
                    </a:r>
                    <a:endParaRPr lang="en-GB" sz="1317" i="1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  <a:p>
                    <a:r>
                      <a:rPr lang="en-GB" sz="1317" i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Bacteroides</a:t>
                    </a:r>
                  </a:p>
                  <a:p>
                    <a:r>
                      <a:rPr lang="en-GB" sz="1317" i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Lactobacillus</a:t>
                    </a:r>
                  </a:p>
                  <a:p>
                    <a:r>
                      <a:rPr lang="en-GB" sz="1317" i="1" dirty="0" err="1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Pyramidobacter</a:t>
                    </a:r>
                    <a:endParaRPr lang="en-GB" sz="1317" i="1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  <a:p>
                    <a:pPr>
                      <a:spcBef>
                        <a:spcPts val="132"/>
                      </a:spcBef>
                    </a:pPr>
                    <a:r>
                      <a:rPr lang="en-GB" sz="1317" i="1" dirty="0" err="1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Selenomonas</a:t>
                    </a:r>
                    <a:endParaRPr lang="en-GB" sz="1317" i="1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  <a:p>
                    <a:pPr>
                      <a:spcBef>
                        <a:spcPts val="132"/>
                      </a:spcBef>
                    </a:pPr>
                    <a:r>
                      <a:rPr lang="en-GB" sz="1317" i="1" dirty="0" err="1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Megamonas</a:t>
                    </a:r>
                    <a:endParaRPr lang="en-GB" sz="1317" i="1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  <a:p>
                    <a:pPr>
                      <a:spcBef>
                        <a:spcPts val="132"/>
                      </a:spcBef>
                    </a:pPr>
                    <a:r>
                      <a:rPr lang="en-GB" sz="1317" i="1" dirty="0" err="1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Morganella</a:t>
                    </a:r>
                    <a:endParaRPr lang="en-GB" sz="1317" i="1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  <a:p>
                    <a:pPr>
                      <a:spcBef>
                        <a:spcPts val="132"/>
                      </a:spcBef>
                    </a:pPr>
                    <a:r>
                      <a:rPr lang="en-GB" sz="1317" i="1" dirty="0" err="1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Veillonella</a:t>
                    </a:r>
                    <a:endParaRPr lang="en-GB" sz="1317" i="1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  <a:p>
                    <a:pPr>
                      <a:spcBef>
                        <a:spcPts val="132"/>
                      </a:spcBef>
                    </a:pPr>
                    <a:r>
                      <a:rPr lang="en-GB" sz="1317" i="1" dirty="0" err="1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Akkermansia</a:t>
                    </a:r>
                    <a:endParaRPr lang="en-GB" sz="1317" i="1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  <a:p>
                    <a:pPr>
                      <a:spcBef>
                        <a:spcPts val="132"/>
                      </a:spcBef>
                    </a:pPr>
                    <a:r>
                      <a:rPr lang="en-GB" sz="1317" i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Bifidobacterium</a:t>
                    </a:r>
                  </a:p>
                  <a:p>
                    <a:r>
                      <a:rPr lang="en-GB" sz="1317" i="1" dirty="0" err="1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Collinsella</a:t>
                    </a:r>
                    <a:endParaRPr lang="en-GB" sz="1317" i="1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  <a:p>
                    <a:r>
                      <a:rPr lang="en-GB" sz="1317" i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Parabacteroides</a:t>
                    </a:r>
                  </a:p>
                  <a:p>
                    <a:r>
                      <a:rPr lang="en-GB" sz="1317" i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Streptococcus</a:t>
                    </a:r>
                  </a:p>
                  <a:p>
                    <a:r>
                      <a:rPr lang="en-GB" sz="1317" i="1" dirty="0" err="1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Leuconostoc</a:t>
                    </a:r>
                    <a:endParaRPr lang="en-GB" sz="1317" i="1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  <a:p>
                    <a:pPr>
                      <a:spcBef>
                        <a:spcPts val="132"/>
                      </a:spcBef>
                    </a:pPr>
                    <a:r>
                      <a:rPr lang="en-GB" sz="1317" i="1" dirty="0" err="1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Eggerthela</a:t>
                    </a:r>
                    <a:endParaRPr lang="en-GB" sz="1317" i="1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  <a:p>
                    <a:pPr>
                      <a:spcBef>
                        <a:spcPts val="132"/>
                      </a:spcBef>
                    </a:pPr>
                    <a:r>
                      <a:rPr lang="en-GB" sz="1317" i="1" dirty="0" err="1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Plesiomonas</a:t>
                    </a:r>
                    <a:endParaRPr lang="en-GB" sz="1317" i="1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  <a:p>
                    <a:r>
                      <a:rPr lang="en-GB" sz="1317" i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Serratia</a:t>
                    </a:r>
                  </a:p>
                  <a:p>
                    <a:pPr>
                      <a:spcBef>
                        <a:spcPts val="263"/>
                      </a:spcBef>
                    </a:pPr>
                    <a:r>
                      <a:rPr lang="en-GB" sz="1317" i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Salmonella</a:t>
                    </a:r>
                  </a:p>
                  <a:p>
                    <a:pPr>
                      <a:spcBef>
                        <a:spcPts val="132"/>
                      </a:spcBef>
                    </a:pPr>
                    <a:r>
                      <a:rPr lang="en-GB" sz="1317" i="1" dirty="0" err="1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Candidatus_Regiel</a:t>
                    </a:r>
                    <a:endParaRPr lang="en-GB" sz="1317" i="1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  <a:p>
                    <a:pPr>
                      <a:spcBef>
                        <a:spcPts val="132"/>
                      </a:spcBef>
                    </a:pPr>
                    <a:r>
                      <a:rPr lang="en-GB" sz="1317" i="1" dirty="0" err="1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Rothia</a:t>
                    </a:r>
                    <a:endParaRPr lang="en-GB" sz="1317" i="1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  <a:p>
                    <a:pPr>
                      <a:spcBef>
                        <a:spcPts val="132"/>
                      </a:spcBef>
                    </a:pPr>
                    <a:r>
                      <a:rPr lang="en-GB" sz="1317" i="1" dirty="0" err="1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Cronobacter</a:t>
                    </a:r>
                    <a:endParaRPr lang="en-GB" sz="1317" i="1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  <a:p>
                    <a:pPr>
                      <a:spcBef>
                        <a:spcPts val="263"/>
                      </a:spcBef>
                    </a:pPr>
                    <a:r>
                      <a:rPr lang="en-GB" sz="1317" i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Haemophilus</a:t>
                    </a:r>
                  </a:p>
                  <a:p>
                    <a:pPr>
                      <a:spcBef>
                        <a:spcPts val="132"/>
                      </a:spcBef>
                    </a:pPr>
                    <a:r>
                      <a:rPr lang="en-GB" sz="1317" i="1" dirty="0" err="1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Desulfovibrio</a:t>
                    </a:r>
                    <a:endParaRPr lang="en-GB" sz="1317" i="1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  <a:p>
                    <a:pPr>
                      <a:spcBef>
                        <a:spcPts val="395"/>
                      </a:spcBef>
                    </a:pPr>
                    <a:r>
                      <a:rPr lang="en-GB" sz="1317" i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Enterobacter</a:t>
                    </a:r>
                  </a:p>
                  <a:p>
                    <a:pPr>
                      <a:spcBef>
                        <a:spcPts val="395"/>
                      </a:spcBef>
                    </a:pPr>
                    <a:r>
                      <a:rPr lang="en-GB" sz="1317" i="1" dirty="0" err="1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Roseburia</a:t>
                    </a:r>
                    <a:endParaRPr lang="en-GB" sz="1317" i="1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  <a:p>
                    <a:pPr>
                      <a:spcBef>
                        <a:spcPts val="263"/>
                      </a:spcBef>
                    </a:pPr>
                    <a:r>
                      <a:rPr lang="en-GB" sz="1317" i="1" dirty="0" err="1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Desulfosporosinus</a:t>
                    </a:r>
                    <a:endParaRPr lang="en-GB" sz="1317" i="1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  <a:p>
                    <a:pPr>
                      <a:spcBef>
                        <a:spcPts val="263"/>
                      </a:spcBef>
                    </a:pPr>
                    <a:r>
                      <a:rPr lang="en-GB" sz="1317" i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Eubacterium</a:t>
                    </a:r>
                  </a:p>
                </p:txBody>
              </p:sp>
              <p:pic>
                <p:nvPicPr>
                  <p:cNvPr id="12" name="Imagem 11">
                    <a:extLst>
                      <a:ext uri="{FF2B5EF4-FFF2-40B4-BE49-F238E27FC236}">
                        <a16:creationId xmlns:a16="http://schemas.microsoft.com/office/drawing/2014/main" id="{CA1FBBC5-2403-411C-AE15-170D76C596D1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 rotWithShape="1">
                  <a:blip r:embed="rId2"/>
                  <a:srcRect r="26044" b="5017"/>
                  <a:stretch/>
                </p:blipFill>
                <p:spPr>
                  <a:xfrm>
                    <a:off x="2282327" y="434276"/>
                    <a:ext cx="4093443" cy="5914439"/>
                  </a:xfrm>
                  <a:prstGeom prst="rect">
                    <a:avLst/>
                  </a:prstGeom>
                </p:spPr>
              </p:pic>
            </p:grpSp>
            <p:grpSp>
              <p:nvGrpSpPr>
                <p:cNvPr id="16" name="Agrupar 15">
                  <a:extLst>
                    <a:ext uri="{FF2B5EF4-FFF2-40B4-BE49-F238E27FC236}">
                      <a16:creationId xmlns:a16="http://schemas.microsoft.com/office/drawing/2014/main" id="{BE181835-3FF9-40E8-84D7-13DDABAB9D15}"/>
                    </a:ext>
                  </a:extLst>
                </p:cNvPr>
                <p:cNvGrpSpPr/>
                <p:nvPr/>
              </p:nvGrpSpPr>
              <p:grpSpPr>
                <a:xfrm>
                  <a:off x="9811228" y="2773212"/>
                  <a:ext cx="6333634" cy="10827961"/>
                  <a:chOff x="1593157" y="260553"/>
                  <a:chExt cx="6333634" cy="10827960"/>
                </a:xfrm>
              </p:grpSpPr>
              <p:pic>
                <p:nvPicPr>
                  <p:cNvPr id="17" name="Imagem 16">
                    <a:extLst>
                      <a:ext uri="{FF2B5EF4-FFF2-40B4-BE49-F238E27FC236}">
                        <a16:creationId xmlns:a16="http://schemas.microsoft.com/office/drawing/2014/main" id="{74DF6A97-751B-493A-8EDE-49CF7039ED95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 rotWithShape="1">
                  <a:blip r:embed="rId3"/>
                  <a:srcRect r="33356" b="3477"/>
                  <a:stretch/>
                </p:blipFill>
                <p:spPr>
                  <a:xfrm>
                    <a:off x="1593157" y="621954"/>
                    <a:ext cx="3744228" cy="10303635"/>
                  </a:xfrm>
                  <a:prstGeom prst="rect">
                    <a:avLst/>
                  </a:prstGeom>
                </p:spPr>
              </p:pic>
              <p:sp>
                <p:nvSpPr>
                  <p:cNvPr id="18" name="CaixaDeTexto 17">
                    <a:extLst>
                      <a:ext uri="{FF2B5EF4-FFF2-40B4-BE49-F238E27FC236}">
                        <a16:creationId xmlns:a16="http://schemas.microsoft.com/office/drawing/2014/main" id="{C5AFF205-A36D-43AE-BAEA-9C770FE97E12}"/>
                      </a:ext>
                    </a:extLst>
                  </p:cNvPr>
                  <p:cNvSpPr txBox="1"/>
                  <p:nvPr/>
                </p:nvSpPr>
                <p:spPr>
                  <a:xfrm>
                    <a:off x="5324268" y="707086"/>
                    <a:ext cx="2602523" cy="10381427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GB" sz="1317" i="1" dirty="0" err="1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Coprococcus</a:t>
                    </a:r>
                    <a:r>
                      <a:rPr lang="en-GB" sz="1317" i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 </a:t>
                    </a:r>
                    <a:r>
                      <a:rPr lang="en-GB" sz="1317" i="1" dirty="0" err="1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eutactus</a:t>
                    </a:r>
                    <a:endParaRPr lang="en-GB" sz="1317" i="1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  <a:p>
                    <a:r>
                      <a:rPr lang="en-GB" sz="1317" i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Eubacterium </a:t>
                    </a:r>
                    <a:r>
                      <a:rPr lang="en-GB" sz="1317" i="1" dirty="0" err="1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cylindroides</a:t>
                    </a:r>
                    <a:endParaRPr lang="en-GB" sz="1317" i="1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  <a:p>
                    <a:r>
                      <a:rPr lang="en-GB" sz="1317" i="1" dirty="0" err="1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Prevotella</a:t>
                    </a:r>
                    <a:r>
                      <a:rPr lang="en-GB" sz="1317" i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 </a:t>
                    </a:r>
                    <a:r>
                      <a:rPr lang="en-GB" sz="1317" i="1" dirty="0" err="1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melaninogenica</a:t>
                    </a:r>
                    <a:endParaRPr lang="en-GB" sz="1317" i="1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  <a:p>
                    <a:r>
                      <a:rPr lang="en-GB" sz="1317" i="1" dirty="0" err="1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Prevotella</a:t>
                    </a:r>
                    <a:r>
                      <a:rPr lang="en-GB" sz="1317" i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 </a:t>
                    </a:r>
                    <a:r>
                      <a:rPr lang="en-GB" sz="1317" i="1" dirty="0" err="1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stercorea</a:t>
                    </a:r>
                    <a:endParaRPr lang="en-GB" sz="1317" i="1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  <a:p>
                    <a:r>
                      <a:rPr lang="en-GB" sz="1317" i="1" dirty="0" err="1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Oscillospira</a:t>
                    </a:r>
                    <a:r>
                      <a:rPr lang="en-GB" sz="1317" i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 </a:t>
                    </a:r>
                    <a:r>
                      <a:rPr lang="en-GB" sz="1317" i="1" dirty="0" err="1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guilliermondii</a:t>
                    </a:r>
                    <a:endParaRPr lang="en-GB" sz="1317" i="1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  <a:p>
                    <a:r>
                      <a:rPr lang="en-GB" sz="1317" i="1" dirty="0" err="1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Prevotella</a:t>
                    </a:r>
                    <a:r>
                      <a:rPr lang="en-GB" sz="1317" i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 </a:t>
                    </a:r>
                    <a:r>
                      <a:rPr lang="en-GB" sz="1317" i="1" dirty="0" err="1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tannerae</a:t>
                    </a:r>
                    <a:endParaRPr lang="en-GB" sz="1317" i="1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  <a:p>
                    <a:r>
                      <a:rPr lang="en-GB" sz="1317" i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Clostridium </a:t>
                    </a:r>
                    <a:r>
                      <a:rPr lang="en-GB" sz="1317" i="1" dirty="0" err="1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intestinale</a:t>
                    </a:r>
                    <a:endParaRPr lang="en-GB" sz="1317" i="1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  <a:p>
                    <a:r>
                      <a:rPr lang="en-GB" sz="1317" i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Bacteroides </a:t>
                    </a:r>
                    <a:r>
                      <a:rPr lang="en-GB" sz="1317" i="1" dirty="0" err="1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plebeius</a:t>
                    </a:r>
                    <a:endParaRPr lang="en-GB" sz="1317" i="1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  <a:p>
                    <a:r>
                      <a:rPr lang="en-GB" sz="1317" i="1" dirty="0" err="1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Prevotella</a:t>
                    </a:r>
                    <a:r>
                      <a:rPr lang="en-GB" sz="1317" i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 </a:t>
                    </a:r>
                    <a:r>
                      <a:rPr lang="en-GB" sz="1317" i="1" dirty="0" err="1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copri</a:t>
                    </a:r>
                    <a:endParaRPr lang="en-GB" sz="1317" i="1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  <a:p>
                    <a:r>
                      <a:rPr lang="en-GB" sz="1317" i="1" dirty="0" err="1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Cellulosibacter</a:t>
                    </a:r>
                    <a:r>
                      <a:rPr lang="en-GB" sz="1317" i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 </a:t>
                    </a:r>
                    <a:r>
                      <a:rPr lang="en-GB" sz="1317" i="1" dirty="0" err="1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alkalithermophilus</a:t>
                    </a:r>
                    <a:endParaRPr lang="en-GB" sz="1317" i="1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  <a:p>
                    <a:r>
                      <a:rPr lang="en-GB" sz="1317" i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Clostridium tetani</a:t>
                    </a:r>
                  </a:p>
                  <a:p>
                    <a:r>
                      <a:rPr lang="en-GB" sz="1317" i="1" dirty="0" err="1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Selenomonas</a:t>
                    </a:r>
                    <a:r>
                      <a:rPr lang="en-GB" sz="1317" i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 </a:t>
                    </a:r>
                    <a:r>
                      <a:rPr lang="en-GB" sz="1317" i="1" dirty="0" err="1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noxia</a:t>
                    </a:r>
                    <a:endParaRPr lang="en-GB" sz="1317" i="1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  <a:p>
                    <a:r>
                      <a:rPr lang="en-GB" sz="1317" i="1" dirty="0" err="1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Collinsella</a:t>
                    </a:r>
                    <a:r>
                      <a:rPr lang="en-GB" sz="1317" i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 </a:t>
                    </a:r>
                    <a:r>
                      <a:rPr lang="en-GB" sz="1317" i="1" dirty="0" err="1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stercoris</a:t>
                    </a:r>
                    <a:endParaRPr lang="en-GB" sz="1317" i="1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  <a:p>
                    <a:r>
                      <a:rPr lang="en-GB" sz="1317" i="1" dirty="0" err="1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Megamonas</a:t>
                    </a:r>
                    <a:r>
                      <a:rPr lang="en-GB" sz="1317" i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 </a:t>
                    </a:r>
                    <a:r>
                      <a:rPr lang="en-GB" sz="1317" i="1" dirty="0" err="1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hypermegale</a:t>
                    </a:r>
                    <a:endParaRPr lang="en-GB" sz="1317" i="1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  <a:p>
                    <a:r>
                      <a:rPr lang="en-GB" sz="1317" i="1" dirty="0" err="1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Morganella</a:t>
                    </a:r>
                    <a:r>
                      <a:rPr lang="en-GB" sz="1317" i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 morganii</a:t>
                    </a:r>
                  </a:p>
                  <a:p>
                    <a:r>
                      <a:rPr lang="en-GB" sz="1317" i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Bacteroides </a:t>
                    </a:r>
                    <a:r>
                      <a:rPr lang="en-GB" sz="1317" i="1" dirty="0" err="1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barnesiae</a:t>
                    </a:r>
                    <a:endParaRPr lang="en-GB" sz="1317" i="1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  <a:p>
                    <a:r>
                      <a:rPr lang="en-GB" sz="1317" i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Bacteroides </a:t>
                    </a:r>
                    <a:r>
                      <a:rPr lang="en-GB" sz="1317" i="1" dirty="0" err="1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coprophilus</a:t>
                    </a:r>
                    <a:endParaRPr lang="en-GB" sz="1317" i="1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  <a:p>
                    <a:r>
                      <a:rPr lang="en-GB" sz="1317" i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Clostridium perfringens</a:t>
                    </a:r>
                  </a:p>
                  <a:p>
                    <a:r>
                      <a:rPr lang="en-GB" sz="1317" i="1" dirty="0" err="1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Collinsela</a:t>
                    </a:r>
                    <a:r>
                      <a:rPr lang="en-GB" sz="1317" i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 </a:t>
                    </a:r>
                    <a:r>
                      <a:rPr lang="en-GB" sz="1317" i="1" dirty="0" err="1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aerofaciens</a:t>
                    </a:r>
                    <a:endParaRPr lang="en-GB" sz="1317" i="1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  <a:p>
                    <a:r>
                      <a:rPr lang="en-GB" sz="1317" i="1" dirty="0" err="1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Prevotella</a:t>
                    </a:r>
                    <a:r>
                      <a:rPr lang="en-GB" sz="1317" i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 </a:t>
                    </a:r>
                    <a:r>
                      <a:rPr lang="en-GB" sz="1317" i="1" dirty="0" err="1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nanceiensis</a:t>
                    </a:r>
                    <a:endParaRPr lang="en-GB" sz="1317" i="1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  <a:p>
                    <a:r>
                      <a:rPr lang="en-GB" sz="1317" i="1" dirty="0" err="1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Veillonella</a:t>
                    </a:r>
                    <a:r>
                      <a:rPr lang="en-GB" sz="1317" i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 </a:t>
                    </a:r>
                    <a:r>
                      <a:rPr lang="en-GB" sz="1317" i="1" dirty="0" err="1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dispar</a:t>
                    </a:r>
                    <a:endParaRPr lang="en-GB" sz="1317" i="1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  <a:p>
                    <a:r>
                      <a:rPr lang="en-GB" sz="1317" i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Parabacteroides </a:t>
                    </a:r>
                    <a:r>
                      <a:rPr lang="en-GB" sz="1317" i="1" dirty="0" err="1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distasonis</a:t>
                    </a:r>
                    <a:endParaRPr lang="en-GB" sz="1317" i="1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  <a:p>
                    <a:r>
                      <a:rPr lang="en-GB" sz="1317" i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Bifidobacterium longum</a:t>
                    </a:r>
                  </a:p>
                  <a:p>
                    <a:r>
                      <a:rPr lang="en-GB" sz="1317" i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Bifidobacterium bifidum</a:t>
                    </a:r>
                  </a:p>
                  <a:p>
                    <a:r>
                      <a:rPr lang="en-GB" sz="1317" i="1" dirty="0" err="1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Akkermansia</a:t>
                    </a:r>
                    <a:r>
                      <a:rPr lang="en-GB" sz="1317" i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 </a:t>
                    </a:r>
                    <a:r>
                      <a:rPr lang="en-GB" sz="1317" i="1" dirty="0" err="1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muciniphila</a:t>
                    </a:r>
                    <a:endParaRPr lang="en-GB" sz="1317" i="1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  <a:p>
                    <a:r>
                      <a:rPr lang="en-GB" sz="1317" i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Bifidobacterium </a:t>
                    </a:r>
                    <a:r>
                      <a:rPr lang="en-GB" sz="1317" i="1" dirty="0" err="1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thermacidophilum</a:t>
                    </a:r>
                    <a:endParaRPr lang="en-GB" sz="1317" i="1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  <a:p>
                    <a:r>
                      <a:rPr lang="en-GB" sz="1317" i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Bifidobacterium </a:t>
                    </a:r>
                    <a:r>
                      <a:rPr lang="en-GB" sz="1317" i="1" dirty="0" err="1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adolescentis</a:t>
                    </a:r>
                    <a:endParaRPr lang="en-GB" sz="1317" i="1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  <a:p>
                    <a:r>
                      <a:rPr lang="en-GB" sz="1317" i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Bifidobacterium </a:t>
                    </a:r>
                    <a:r>
                      <a:rPr lang="en-GB" sz="1317" i="1" dirty="0" err="1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pseudologum</a:t>
                    </a:r>
                    <a:endParaRPr lang="en-GB" sz="1317" i="1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  <a:p>
                    <a:r>
                      <a:rPr lang="en-GB" sz="1317" i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Bifidobacterium </a:t>
                    </a:r>
                    <a:r>
                      <a:rPr lang="en-GB" sz="1317" i="1" dirty="0" err="1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animalis</a:t>
                    </a:r>
                    <a:endParaRPr lang="en-GB" sz="1317" i="1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  <a:p>
                    <a:r>
                      <a:rPr lang="en-GB" sz="1317" i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Bifidobacterium breve</a:t>
                    </a:r>
                  </a:p>
                  <a:p>
                    <a:r>
                      <a:rPr lang="en-GB" sz="1317" i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Lactobacillus </a:t>
                    </a:r>
                    <a:r>
                      <a:rPr lang="en-GB" sz="1317" i="1" dirty="0" err="1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reuteri</a:t>
                    </a:r>
                    <a:endParaRPr lang="en-GB" sz="1317" i="1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  <a:p>
                    <a:r>
                      <a:rPr lang="en-GB" sz="1317" i="1" dirty="0" err="1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Ruminococcus</a:t>
                    </a:r>
                    <a:r>
                      <a:rPr lang="en-GB" sz="1317" i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 </a:t>
                    </a:r>
                    <a:r>
                      <a:rPr lang="en-GB" sz="1317" i="1" dirty="0" err="1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callidus</a:t>
                    </a:r>
                    <a:endParaRPr lang="en-GB" sz="1317" i="1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  <a:p>
                    <a:r>
                      <a:rPr lang="en-GB" sz="1317" i="1" dirty="0" err="1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Blautia</a:t>
                    </a:r>
                    <a:r>
                      <a:rPr lang="en-GB" sz="1317" i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 </a:t>
                    </a:r>
                    <a:r>
                      <a:rPr lang="en-GB" sz="1317" i="1" dirty="0" err="1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obeum</a:t>
                    </a:r>
                    <a:endParaRPr lang="en-GB" sz="1317" i="1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  <a:p>
                    <a:r>
                      <a:rPr lang="en-GB" sz="1317" i="1" dirty="0" err="1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Blautia</a:t>
                    </a:r>
                    <a:r>
                      <a:rPr lang="en-GB" sz="1317" i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 </a:t>
                    </a:r>
                    <a:r>
                      <a:rPr lang="en-GB" sz="1317" i="1" dirty="0" err="1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producta</a:t>
                    </a:r>
                    <a:endParaRPr lang="en-GB" sz="1317" i="1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  <a:p>
                    <a:r>
                      <a:rPr lang="en-GB" sz="1317" i="1" dirty="0" err="1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Ruminococcus</a:t>
                    </a:r>
                    <a:r>
                      <a:rPr lang="en-GB" sz="1317" i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 </a:t>
                    </a:r>
                    <a:r>
                      <a:rPr lang="en-GB" sz="1317" i="1" dirty="0" err="1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flavefaciens</a:t>
                    </a:r>
                    <a:endParaRPr lang="en-GB" sz="1317" i="1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  <a:p>
                    <a:r>
                      <a:rPr lang="en-GB" sz="1317" i="1" dirty="0" err="1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Dorea</a:t>
                    </a:r>
                    <a:r>
                      <a:rPr lang="en-GB" sz="1317" i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 </a:t>
                    </a:r>
                    <a:r>
                      <a:rPr lang="en-GB" sz="1317" i="1" dirty="0" err="1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formicigenerans</a:t>
                    </a:r>
                    <a:endParaRPr lang="en-GB" sz="1317" i="1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  <a:p>
                    <a:r>
                      <a:rPr lang="en-GB" sz="1317" i="1" dirty="0" err="1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Ruminococcus</a:t>
                    </a:r>
                    <a:r>
                      <a:rPr lang="en-GB" sz="1317" i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 </a:t>
                    </a:r>
                    <a:r>
                      <a:rPr lang="en-GB" sz="1317" i="1" dirty="0" err="1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gnavus</a:t>
                    </a:r>
                    <a:endParaRPr lang="en-GB" sz="1317" i="1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  <a:p>
                    <a:r>
                      <a:rPr lang="en-GB" sz="1317" i="1" dirty="0" err="1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Ruminococcus</a:t>
                    </a:r>
                    <a:r>
                      <a:rPr lang="en-GB" sz="1317" i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 torques</a:t>
                    </a:r>
                  </a:p>
                  <a:p>
                    <a:r>
                      <a:rPr lang="en-GB" sz="1317" i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Bacteroides </a:t>
                    </a:r>
                    <a:r>
                      <a:rPr lang="en-GB" sz="1317" i="1" dirty="0" err="1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eggerthii</a:t>
                    </a:r>
                    <a:endParaRPr lang="en-GB" sz="1317" i="1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  <a:p>
                    <a:r>
                      <a:rPr lang="en-GB" sz="1317" i="1" dirty="0" err="1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Ruminococcus</a:t>
                    </a:r>
                    <a:r>
                      <a:rPr lang="en-GB" sz="1317" i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 </a:t>
                    </a:r>
                    <a:r>
                      <a:rPr lang="en-GB" sz="1317" i="1" dirty="0" err="1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bromii</a:t>
                    </a:r>
                    <a:endParaRPr lang="en-GB" sz="1317" i="1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  <a:p>
                    <a:r>
                      <a:rPr lang="en-GB" sz="1317" i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Bacteroides </a:t>
                    </a:r>
                    <a:r>
                      <a:rPr lang="en-GB" sz="1317" i="1" dirty="0" err="1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uniformis</a:t>
                    </a:r>
                    <a:endParaRPr lang="en-GB" sz="1317" i="1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  <a:p>
                    <a:r>
                      <a:rPr lang="en-GB" sz="1317" i="1" dirty="0" err="1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Pyramidobacter</a:t>
                    </a:r>
                    <a:r>
                      <a:rPr lang="en-GB" sz="1317" i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 </a:t>
                    </a:r>
                    <a:r>
                      <a:rPr lang="en-GB" sz="1317" i="1" dirty="0" err="1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piscolens</a:t>
                    </a:r>
                    <a:endParaRPr lang="en-GB" sz="1317" i="1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  <a:p>
                    <a:r>
                      <a:rPr lang="en-GB" sz="1317" i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Bacteroides </a:t>
                    </a:r>
                    <a:r>
                      <a:rPr lang="en-GB" sz="1317" i="1" dirty="0" err="1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ovathus</a:t>
                    </a:r>
                    <a:endParaRPr lang="en-GB" sz="1317" i="1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  <a:p>
                    <a:r>
                      <a:rPr lang="en-GB" sz="1317" i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Bacteroides </a:t>
                    </a:r>
                    <a:r>
                      <a:rPr lang="en-GB" sz="1317" i="1" dirty="0" err="1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acidifaciens</a:t>
                    </a:r>
                    <a:endParaRPr lang="en-GB" sz="1317" i="1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  <a:p>
                    <a:r>
                      <a:rPr lang="en-GB" sz="1317" i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Bacteroides fragilis</a:t>
                    </a:r>
                  </a:p>
                  <a:p>
                    <a:r>
                      <a:rPr lang="en-GB" sz="1317" i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Bacteroides </a:t>
                    </a:r>
                    <a:r>
                      <a:rPr lang="en-GB" sz="1317" i="1" dirty="0" err="1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caccae</a:t>
                    </a:r>
                    <a:endParaRPr lang="en-GB" sz="1317" i="1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  <a:p>
                    <a:r>
                      <a:rPr lang="en-GB" sz="1317" i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Eubacterium </a:t>
                    </a:r>
                    <a:r>
                      <a:rPr lang="en-GB" sz="1317" i="1" dirty="0" err="1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dolichum</a:t>
                    </a:r>
                    <a:endParaRPr lang="en-GB" sz="1317" i="1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  <a:p>
                    <a:r>
                      <a:rPr lang="en-GB" sz="1317" i="1" dirty="0" err="1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Veilonela</a:t>
                    </a:r>
                    <a:r>
                      <a:rPr lang="en-GB" sz="1317" i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 </a:t>
                    </a:r>
                    <a:r>
                      <a:rPr lang="en-GB" sz="1317" i="1" dirty="0" err="1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parvula</a:t>
                    </a:r>
                    <a:endParaRPr lang="en-GB" sz="1317" i="1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  <a:p>
                    <a:r>
                      <a:rPr lang="en-GB" sz="1317" i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Clostridium </a:t>
                    </a:r>
                    <a:r>
                      <a:rPr lang="en-GB" sz="1317" i="1" dirty="0" err="1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butyricum</a:t>
                    </a:r>
                    <a:endParaRPr lang="en-GB" sz="1317" i="1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  <a:p>
                    <a:r>
                      <a:rPr lang="en-GB" sz="1317" i="1" dirty="0" err="1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Oxalobacter</a:t>
                    </a:r>
                    <a:r>
                      <a:rPr lang="en-GB" sz="1317" i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 </a:t>
                    </a:r>
                    <a:r>
                      <a:rPr lang="en-GB" sz="1317" i="1" dirty="0" err="1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formigenes</a:t>
                    </a:r>
                    <a:endParaRPr lang="en-GB" sz="1317" i="1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  <a:p>
                    <a:r>
                      <a:rPr lang="en-GB" sz="1317" i="1" dirty="0" err="1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Roseburia</a:t>
                    </a:r>
                    <a:r>
                      <a:rPr lang="en-GB" sz="1317" i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 </a:t>
                    </a:r>
                    <a:r>
                      <a:rPr lang="en-GB" sz="1317" i="1" dirty="0" err="1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faecis</a:t>
                    </a:r>
                    <a:endParaRPr lang="en-GB" sz="1317" i="1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  <a:p>
                    <a:r>
                      <a:rPr lang="en-GB" sz="1317" i="1" dirty="0" err="1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Desulfosporosinus</a:t>
                    </a:r>
                    <a:r>
                      <a:rPr lang="en-GB" sz="1317" i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 </a:t>
                    </a:r>
                    <a:r>
                      <a:rPr lang="en-GB" sz="1317" i="1" dirty="0" err="1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meridiei</a:t>
                    </a:r>
                    <a:endParaRPr lang="en-GB" sz="1317" i="1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  <a:p>
                    <a:r>
                      <a:rPr lang="en-GB" sz="1317" i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Eubacterium </a:t>
                    </a:r>
                    <a:r>
                      <a:rPr lang="en-GB" sz="1317" i="1" dirty="0" err="1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biforme</a:t>
                    </a:r>
                    <a:endParaRPr lang="en-GB" sz="1317" i="1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  <a:p>
                    <a:r>
                      <a:rPr lang="en-GB" sz="1317" i="1" dirty="0" err="1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Faecalibacterium</a:t>
                    </a:r>
                    <a:r>
                      <a:rPr lang="en-GB" sz="1317" i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 </a:t>
                    </a:r>
                    <a:r>
                      <a:rPr lang="en-GB" sz="1317" i="1" dirty="0" err="1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prausnitzii</a:t>
                    </a:r>
                    <a:endParaRPr lang="en-GB" sz="1317" i="1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  <a:p>
                    <a:r>
                      <a:rPr lang="en-GB" sz="1317" i="1" dirty="0" err="1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Coprococcus</a:t>
                    </a:r>
                    <a:r>
                      <a:rPr lang="en-GB" sz="1317" i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 </a:t>
                    </a:r>
                    <a:r>
                      <a:rPr lang="en-GB" sz="1317" i="1" dirty="0" err="1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catus</a:t>
                    </a:r>
                    <a:endParaRPr lang="en-GB" sz="1317" i="1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  <a:p>
                    <a:r>
                      <a:rPr lang="en-GB" sz="1317" i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Streptococcus </a:t>
                    </a:r>
                    <a:r>
                      <a:rPr lang="en-GB" sz="1317" i="1" dirty="0" err="1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luteciae</a:t>
                    </a:r>
                    <a:endParaRPr lang="en-GB" sz="1317" i="1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  <a:p>
                    <a:r>
                      <a:rPr lang="en-GB" sz="1317" i="1" dirty="0" err="1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Leuconostic</a:t>
                    </a:r>
                    <a:r>
                      <a:rPr lang="en-GB" sz="1317" i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 </a:t>
                    </a:r>
                    <a:r>
                      <a:rPr lang="en-GB" sz="1317" i="1" dirty="0" err="1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mesenteroides</a:t>
                    </a:r>
                    <a:endParaRPr lang="en-GB" sz="1317" i="1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  <a:p>
                    <a:r>
                      <a:rPr lang="en-GB" sz="1317" i="1" dirty="0" err="1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Eggerthella</a:t>
                    </a:r>
                    <a:r>
                      <a:rPr lang="en-GB" sz="1317" i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 </a:t>
                    </a:r>
                    <a:r>
                      <a:rPr lang="en-GB" sz="1317" i="1" dirty="0" err="1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lenta</a:t>
                    </a:r>
                    <a:endParaRPr lang="en-GB" sz="1317" i="1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  <a:p>
                    <a:r>
                      <a:rPr lang="en-GB" sz="1317" i="1" dirty="0" err="1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Plesiomonas</a:t>
                    </a:r>
                    <a:r>
                      <a:rPr lang="en-GB" sz="1317" i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 </a:t>
                    </a:r>
                    <a:r>
                      <a:rPr lang="en-GB" sz="1317" i="1" dirty="0" err="1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shigelloides</a:t>
                    </a:r>
                    <a:endParaRPr lang="en-GB" sz="1317" i="1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  <a:p>
                    <a:r>
                      <a:rPr lang="en-GB" sz="1317" i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Serratia marcescens</a:t>
                    </a:r>
                  </a:p>
                  <a:p>
                    <a:r>
                      <a:rPr lang="en-GB" sz="1317" i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Salmonella enterica</a:t>
                    </a:r>
                  </a:p>
                  <a:p>
                    <a:r>
                      <a:rPr lang="en-GB" sz="1317" i="1" dirty="0" err="1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Candidatus</a:t>
                    </a:r>
                    <a:r>
                      <a:rPr lang="en-GB" sz="1317" i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 </a:t>
                    </a:r>
                    <a:r>
                      <a:rPr lang="en-GB" sz="1317" i="1" dirty="0" err="1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Regiella</a:t>
                    </a:r>
                    <a:r>
                      <a:rPr lang="en-GB" sz="1317" i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 </a:t>
                    </a:r>
                    <a:r>
                      <a:rPr lang="en-GB" sz="1317" i="1" dirty="0" err="1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insecticola</a:t>
                    </a:r>
                    <a:endParaRPr lang="en-GB" sz="1317" i="1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  <a:p>
                    <a:r>
                      <a:rPr lang="en-GB" sz="1317" i="1" dirty="0" err="1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Rothia</a:t>
                    </a:r>
                    <a:r>
                      <a:rPr lang="en-GB" sz="1317" i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 </a:t>
                    </a:r>
                    <a:r>
                      <a:rPr lang="en-GB" sz="1317" i="1" dirty="0" err="1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mucilaginosa</a:t>
                    </a:r>
                    <a:endParaRPr lang="en-GB" sz="1317" i="1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  <a:p>
                    <a:r>
                      <a:rPr lang="en-GB" sz="1317" i="1" dirty="0" err="1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Cronobacter</a:t>
                    </a:r>
                    <a:r>
                      <a:rPr lang="en-GB" sz="1317" i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 </a:t>
                    </a:r>
                    <a:r>
                      <a:rPr lang="en-GB" sz="1317" i="1" dirty="0" err="1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sakazakii</a:t>
                    </a:r>
                    <a:endParaRPr lang="en-GB" sz="1317" i="1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  <a:p>
                    <a:r>
                      <a:rPr lang="en-GB" sz="1317" i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Haemophilus </a:t>
                    </a:r>
                    <a:r>
                      <a:rPr lang="en-GB" sz="1317" i="1" dirty="0" err="1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parainfluenzae</a:t>
                    </a:r>
                    <a:endParaRPr lang="en-GB" sz="1317" i="1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  <a:p>
                    <a:r>
                      <a:rPr lang="en-GB" sz="1317" i="1" dirty="0" err="1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Desulfovibrio</a:t>
                    </a:r>
                    <a:r>
                      <a:rPr lang="en-GB" sz="1317" i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 D168</a:t>
                    </a:r>
                  </a:p>
                  <a:p>
                    <a:r>
                      <a:rPr lang="en-GB" sz="1317" i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Enterobacter cloacae</a:t>
                    </a:r>
                  </a:p>
                </p:txBody>
              </p:sp>
              <p:pic>
                <p:nvPicPr>
                  <p:cNvPr id="19" name="Imagem 18">
                    <a:extLst>
                      <a:ext uri="{FF2B5EF4-FFF2-40B4-BE49-F238E27FC236}">
                        <a16:creationId xmlns:a16="http://schemas.microsoft.com/office/drawing/2014/main" id="{9A3BBD5D-7961-460A-92F1-07FB0735C0D8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 rotWithShape="1">
                  <a:blip r:embed="rId2"/>
                  <a:srcRect l="84656" r="11561" b="80750"/>
                  <a:stretch/>
                </p:blipFill>
                <p:spPr>
                  <a:xfrm>
                    <a:off x="7489860" y="260553"/>
                    <a:ext cx="409539" cy="2344004"/>
                  </a:xfrm>
                  <a:prstGeom prst="rect">
                    <a:avLst/>
                  </a:prstGeom>
                </p:spPr>
              </p:pic>
              <p:sp>
                <p:nvSpPr>
                  <p:cNvPr id="20" name="CaixaDeTexto 19">
                    <a:extLst>
                      <a:ext uri="{FF2B5EF4-FFF2-40B4-BE49-F238E27FC236}">
                        <a16:creationId xmlns:a16="http://schemas.microsoft.com/office/drawing/2014/main" id="{A596FBCE-3F34-409E-BF3D-F6B192F59D14}"/>
                      </a:ext>
                    </a:extLst>
                  </p:cNvPr>
                  <p:cNvSpPr txBox="1"/>
                  <p:nvPr/>
                </p:nvSpPr>
                <p:spPr>
                  <a:xfrm>
                    <a:off x="2102774" y="405540"/>
                    <a:ext cx="1542084" cy="224010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GB" sz="1317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High adherence</a:t>
                    </a:r>
                  </a:p>
                </p:txBody>
              </p:sp>
              <p:sp>
                <p:nvSpPr>
                  <p:cNvPr id="21" name="CaixaDeTexto 20">
                    <a:extLst>
                      <a:ext uri="{FF2B5EF4-FFF2-40B4-BE49-F238E27FC236}">
                        <a16:creationId xmlns:a16="http://schemas.microsoft.com/office/drawing/2014/main" id="{8AC21597-FA5F-4A81-AE39-BBBAAB763FD5}"/>
                      </a:ext>
                    </a:extLst>
                  </p:cNvPr>
                  <p:cNvSpPr txBox="1"/>
                  <p:nvPr/>
                </p:nvSpPr>
                <p:spPr>
                  <a:xfrm>
                    <a:off x="3904635" y="405539"/>
                    <a:ext cx="1321119" cy="224010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GB" sz="1317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Low adherence</a:t>
                    </a:r>
                  </a:p>
                </p:txBody>
              </p:sp>
            </p:grpSp>
          </p:grpSp>
          <p:sp>
            <p:nvSpPr>
              <p:cNvPr id="24" name="CaixaDeTexto 23">
                <a:extLst>
                  <a:ext uri="{FF2B5EF4-FFF2-40B4-BE49-F238E27FC236}">
                    <a16:creationId xmlns:a16="http://schemas.microsoft.com/office/drawing/2014/main" id="{3E1251D0-C516-4E43-A7B5-2A10E683234F}"/>
                  </a:ext>
                </a:extLst>
              </p:cNvPr>
              <p:cNvSpPr txBox="1"/>
              <p:nvPr/>
            </p:nvSpPr>
            <p:spPr>
              <a:xfrm>
                <a:off x="15755818" y="3089555"/>
                <a:ext cx="483358" cy="2240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GB" sz="1317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B</a:t>
                </a:r>
              </a:p>
            </p:txBody>
          </p:sp>
          <p:pic>
            <p:nvPicPr>
              <p:cNvPr id="22" name="Imagem 21">
                <a:extLst>
                  <a:ext uri="{FF2B5EF4-FFF2-40B4-BE49-F238E27FC236}">
                    <a16:creationId xmlns:a16="http://schemas.microsoft.com/office/drawing/2014/main" id="{095C0514-60FE-42B1-89D5-EA9F872750CF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2"/>
              <a:srcRect l="84656" r="11561" b="80750"/>
              <a:stretch/>
            </p:blipFill>
            <p:spPr>
              <a:xfrm>
                <a:off x="8045047" y="3177963"/>
                <a:ext cx="409539" cy="2344004"/>
              </a:xfrm>
              <a:prstGeom prst="rect">
                <a:avLst/>
              </a:prstGeom>
            </p:spPr>
          </p:pic>
        </p:grpSp>
      </p:grpSp>
      <p:sp>
        <p:nvSpPr>
          <p:cNvPr id="25" name="CaixaDeTexto 24">
            <a:extLst>
              <a:ext uri="{FF2B5EF4-FFF2-40B4-BE49-F238E27FC236}">
                <a16:creationId xmlns:a16="http://schemas.microsoft.com/office/drawing/2014/main" id="{48E3A845-524B-4629-8959-B1EE659B270C}"/>
              </a:ext>
            </a:extLst>
          </p:cNvPr>
          <p:cNvSpPr txBox="1"/>
          <p:nvPr/>
        </p:nvSpPr>
        <p:spPr>
          <a:xfrm>
            <a:off x="2784693" y="15696895"/>
            <a:ext cx="17614465" cy="41979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  <a:spcAft>
                <a:spcPts val="1054"/>
              </a:spcAft>
            </a:pPr>
            <a:r>
              <a:rPr lang="en-US" sz="1580" b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Figure S1 – </a:t>
            </a:r>
            <a:r>
              <a:rPr lang="en-US" sz="158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Clustering of bacterial genera (A) and species (B) according to Mediterranean diet adherence visualized as a heatmap. </a:t>
            </a:r>
            <a:endParaRPr lang="pt-PT" sz="1580" dirty="0">
              <a:latin typeface="Arial" panose="020B060402020202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155485485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o Office">
  <a:themeElements>
    <a:clrScheme name="Tema do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Tema do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ema do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Tema do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357</TotalTime>
  <Words>207</Words>
  <Application>Microsoft Office PowerPoint</Application>
  <PresentationFormat>Personalizados</PresentationFormat>
  <Paragraphs>109</Paragraphs>
  <Slides>1</Slides>
  <Notes>0</Notes>
  <HiddenSlides>0</HiddenSlides>
  <MMClips>0</MMClips>
  <ScaleCrop>false</ScaleCrop>
  <HeadingPairs>
    <vt:vector size="6" baseType="variant">
      <vt:variant>
        <vt:lpstr>Tipos de letra usados</vt:lpstr>
      </vt:variant>
      <vt:variant>
        <vt:i4>3</vt:i4>
      </vt:variant>
      <vt:variant>
        <vt:lpstr>Tema</vt:lpstr>
      </vt:variant>
      <vt:variant>
        <vt:i4>1</vt:i4>
      </vt:variant>
      <vt:variant>
        <vt:lpstr>Títulos dos diapositivo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Tema do Office</vt:lpstr>
      <vt:lpstr>Apresentação do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Apresentação do PowerPoint</dc:title>
  <dc:creator>Shámila Ismael</dc:creator>
  <cp:lastModifiedBy>Shámila Ismael</cp:lastModifiedBy>
  <cp:revision>91</cp:revision>
  <dcterms:created xsi:type="dcterms:W3CDTF">2020-12-11T16:55:16Z</dcterms:created>
  <dcterms:modified xsi:type="dcterms:W3CDTF">2021-02-26T19:55:47Z</dcterms:modified>
</cp:coreProperties>
</file>